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olors1.xml" ContentType="application/vnd.ms-office.chartcolorstyle+xml"/>
  <Override PartName="/ppt/charts/colors2.xml" ContentType="application/vnd.ms-office.chartcolorstyle+xml"/>
  <Override PartName="/ppt/charts/colors3.xml" ContentType="application/vnd.ms-office.chartcolorstyle+xml"/>
  <Override PartName="/ppt/charts/colors4.xml" ContentType="application/vnd.ms-office.chartcolorstyle+xml"/>
  <Override PartName="/ppt/charts/colors5.xml" ContentType="application/vnd.ms-office.chartcolorstyle+xml"/>
  <Override PartName="/ppt/charts/colors6.xml" ContentType="application/vnd.ms-office.chartcolorstyle+xml"/>
  <Override PartName="/ppt/charts/colors7.xml" ContentType="application/vnd.ms-office.chartcolorstyle+xml"/>
  <Override PartName="/ppt/charts/colors8.xml" ContentType="application/vnd.ms-office.chartcolorstyle+xml"/>
  <Override PartName="/ppt/charts/colors9.xml" ContentType="application/vnd.ms-office.chartcolorstyle+xml"/>
  <Override PartName="/ppt/charts/style1.xml" ContentType="application/vnd.ms-office.chartstyle+xml"/>
  <Override PartName="/ppt/charts/style2.xml" ContentType="application/vnd.ms-office.chartstyle+xml"/>
  <Override PartName="/ppt/charts/style3.xml" ContentType="application/vnd.ms-office.chartstyle+xml"/>
  <Override PartName="/ppt/charts/style4.xml" ContentType="application/vnd.ms-office.chartstyle+xml"/>
  <Override PartName="/ppt/charts/style5.xml" ContentType="application/vnd.ms-office.chartstyle+xml"/>
  <Override PartName="/ppt/charts/style6.xml" ContentType="application/vnd.ms-office.chartstyle+xml"/>
  <Override PartName="/ppt/charts/style7.xml" ContentType="application/vnd.ms-office.chartstyle+xml"/>
  <Override PartName="/ppt/charts/style8.xml" ContentType="application/vnd.ms-office.chartstyle+xml"/>
  <Override PartName="/ppt/charts/style9.xml" ContentType="application/vnd.ms-office.chartstyle+xml"/>
  <Override PartName="/ppt/drawings/drawing1.xml" ContentType="application/vnd.openxmlformats-officedocument.drawingml.chartshapes+xml"/>
  <Override PartName="/ppt/drawings/drawing2.xml" ContentType="application/vnd.openxmlformats-officedocument.drawingml.chartshapes+xml"/>
  <Override PartName="/ppt/notesMasters/notesMaster1.xml" ContentType="application/vnd.openxmlformats-officedocument.presentationml.notesMaster+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326" r:id="rId2"/>
    <p:sldId id="301" r:id="rId3"/>
    <p:sldId id="308" r:id="rId4"/>
    <p:sldId id="309" r:id="rId5"/>
    <p:sldId id="320" r:id="rId6"/>
    <p:sldId id="297" r:id="rId7"/>
    <p:sldId id="321" r:id="rId8"/>
    <p:sldId id="322" r:id="rId9"/>
    <p:sldId id="323" r:id="rId10"/>
    <p:sldId id="324" r:id="rId11"/>
    <p:sldId id="325"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CC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714" y="72"/>
      </p:cViewPr>
      <p:guideLst/>
    </p:cSldViewPr>
  </p:slideViewPr>
  <p:notesTextViewPr>
    <p:cViewPr>
      <p:scale>
        <a:sx n="1" d="1"/>
        <a:sy n="1" d="1"/>
      </p:scale>
      <p:origin x="0" y="0"/>
    </p:cViewPr>
  </p:notesTextViewPr>
  <p:gridSpacing cx="76200" cy="76200"/>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slide" Target="slides/slide9.xml"/>
   <Relationship Id="rId11" Type="http://schemas.openxmlformats.org/officeDocument/2006/relationships/slide" Target="slides/slide10.xml"/>
   <Relationship Id="rId12" Type="http://schemas.openxmlformats.org/officeDocument/2006/relationships/slide" Target="slides/slide11.xml"/>
   <Relationship Id="rId13" Type="http://schemas.openxmlformats.org/officeDocument/2006/relationships/notesMaster" Target="notesMasters/notesMaster1.xml"/>
   <Relationship Id="rId14" Type="http://schemas.openxmlformats.org/officeDocument/2006/relationships/presProps" Target="presProps.xml"/>
   <Relationship Id="rId15" Type="http://schemas.openxmlformats.org/officeDocument/2006/relationships/viewProps" Target="viewProps.xml"/>
   <Relationship Id="rId16" Type="http://schemas.openxmlformats.org/officeDocument/2006/relationships/theme" Target="theme/theme1.xml"/>
   <Relationship Id="rId17"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slide" Target="slides/slide7.xml"/>
   <Relationship Id="rId9" Type="http://schemas.openxmlformats.org/officeDocument/2006/relationships/slide" Target="slides/slide8.xml"/>
</Relationships>
</file>

<file path=ppt/charts/_rels/chart1.xml.rels><?xml version = '1.0' encoding = 'UTF-8' standalone = 'yes'?>
<Relationships xmlns="http://schemas.openxmlformats.org/package/2006/relationships">
   <Relationship Id="rId1" Type="http://schemas.microsoft.com/office/2011/relationships/chartStyle" Target="style1.xml"/>
   <Relationship Id="rId2" Type="http://schemas.microsoft.com/office/2011/relationships/chartColorStyle" Target="colors1.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2.xml.rels><?xml version = '1.0' encoding = 'UTF-8' standalone = 'yes'?>
<Relationships xmlns="http://schemas.openxmlformats.org/package/2006/relationships">
   <Relationship Id="rId1" Type="http://schemas.microsoft.com/office/2011/relationships/chartStyle" Target="style2.xml"/>
   <Relationship Id="rId2" Type="http://schemas.microsoft.com/office/2011/relationships/chartColorStyle" Target="colors2.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3.xml.rels><?xml version = '1.0' encoding = 'UTF-8' standalone = 'yes'?>
<Relationships xmlns="http://schemas.openxmlformats.org/package/2006/relationships">
   <Relationship Id="rId1" Type="http://schemas.microsoft.com/office/2011/relationships/chartStyle" Target="style3.xml"/>
   <Relationship Id="rId2" Type="http://schemas.microsoft.com/office/2011/relationships/chartColorStyle" Target="colors3.xml"/>
   <Relationship Id="rId3" Type="http://schemas.openxmlformats.org/officeDocument/2006/relationships/oleObject" TargetMode="External" Target="file:///C:/Users/gglinsky/Desktop/2015_2016%20VittorioS/2016_CSC%20VittorioS/HPATs%20BLastocyst%20Cells/HPATs%20Blastocysts.xlsx"/>
   <Relationship Id="rId4" Type="http://schemas.openxmlformats.org/officeDocument/2006/relationships/chartUserShapes" Target="../drawings/drawing1.xml"/>
</Relationships>
</file>

<file path=ppt/charts/_rels/chart4.xml.rels><?xml version = '1.0' encoding = 'UTF-8' standalone = 'yes'?>
<Relationships xmlns="http://schemas.openxmlformats.org/package/2006/relationships">
   <Relationship Id="rId1" Type="http://schemas.microsoft.com/office/2011/relationships/chartStyle" Target="style4.xml"/>
   <Relationship Id="rId2" Type="http://schemas.microsoft.com/office/2011/relationships/chartColorStyle" Target="colors4.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5.xml.rels><?xml version = '1.0' encoding = 'UTF-8' standalone = 'yes'?>
<Relationships xmlns="http://schemas.openxmlformats.org/package/2006/relationships">
   <Relationship Id="rId1" Type="http://schemas.microsoft.com/office/2011/relationships/chartStyle" Target="style5.xml"/>
   <Relationship Id="rId2" Type="http://schemas.microsoft.com/office/2011/relationships/chartColorStyle" Target="colors5.xml"/>
   <Relationship Id="rId3" Type="http://schemas.openxmlformats.org/officeDocument/2006/relationships/oleObject" TargetMode="External" Target="file:///C:/Users/gglinsky/Desktop/2015_2016%20VittorioS/2016_CSC%20VittorioS/HPATs%20BLastocyst%20Cells/HPATs%20Blastocysts.xlsx"/>
   <Relationship Id="rId4" Type="http://schemas.openxmlformats.org/officeDocument/2006/relationships/chartUserShapes" Target="../drawings/drawing2.xml"/>
</Relationships>
</file>

<file path=ppt/charts/_rels/chart6.xml.rels><?xml version = '1.0' encoding = 'UTF-8' standalone = 'yes'?>
<Relationships xmlns="http://schemas.openxmlformats.org/package/2006/relationships">
   <Relationship Id="rId1" Type="http://schemas.microsoft.com/office/2011/relationships/chartStyle" Target="style6.xml"/>
   <Relationship Id="rId2" Type="http://schemas.microsoft.com/office/2011/relationships/chartColorStyle" Target="colors6.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7.xml.rels><?xml version = '1.0' encoding = 'UTF-8' standalone = 'yes'?>
<Relationships xmlns="http://schemas.openxmlformats.org/package/2006/relationships">
   <Relationship Id="rId1" Type="http://schemas.microsoft.com/office/2011/relationships/chartStyle" Target="style7.xml"/>
   <Relationship Id="rId2" Type="http://schemas.microsoft.com/office/2011/relationships/chartColorStyle" Target="colors7.xml"/>
   <Relationship Id="rId3" Type="http://schemas.openxmlformats.org/officeDocument/2006/relationships/oleObject" TargetMode="External" Target="file:///C:/Users/gglinsky/Desktop/2015_2016%20VittorioS/2016_CSC%20VittorioS/HPATs%20BLastocyst%20Cells/Copy1%20of%20HPAT%20region%20and%20labels%20(230385).xlsx"/>
</Relationships>
</file>

<file path=ppt/charts/_rels/chart8.xml.rels><?xml version = '1.0' encoding = 'UTF-8' standalone = 'yes'?>
<Relationships xmlns="http://schemas.openxmlformats.org/package/2006/relationships">
   <Relationship Id="rId1" Type="http://schemas.microsoft.com/office/2011/relationships/chartStyle" Target="style8.xml"/>
   <Relationship Id="rId2" Type="http://schemas.microsoft.com/office/2011/relationships/chartColorStyle" Target="colors8.xml"/>
   <Relationship Id="rId3" Type="http://schemas.openxmlformats.org/officeDocument/2006/relationships/oleObject" TargetMode="External" Target="file:///C:/Users/gglinsky/Desktop/2015_2016%20VittorioS/2016_CSC%20VittorioS/HPATs%20BLastocyst%20Cells/HPATs%20Blastocysts.xlsx"/>
</Relationships>
</file>

<file path=ppt/charts/_rels/chart9.xml.rels><?xml version = '1.0' encoding = 'UTF-8' standalone = 'yes'?>
<Relationships xmlns="http://schemas.openxmlformats.org/package/2006/relationships">
   <Relationship Id="rId1" Type="http://schemas.microsoft.com/office/2011/relationships/chartStyle" Target="style9.xml"/>
   <Relationship Id="rId2" Type="http://schemas.microsoft.com/office/2011/relationships/chartColorStyle" Target="colors9.xml"/>
   <Relationship Id="rId3" Type="http://schemas.openxmlformats.org/officeDocument/2006/relationships/oleObject" TargetMode="External" Target="file:///C:/Users/gglinsky/Desktop/2015_2016%20VittorioS/2016_CSC%20VittorioS/HPATs%20BLastocyst%20Cells/HPATs%20Blastocysts.xlsx"/>
</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21 lincRNA</a:t>
            </a:r>
            <a:endParaRPr lang="en-US">
              <a:solidFill>
                <a:sysClr val="windowText" lastClr="000000"/>
              </a:solidFill>
              <a:effectLst/>
            </a:endParaRPr>
          </a:p>
        </c:rich>
      </c:tx>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301547028360186"/>
          <c:y val="0.14331344180655131"/>
          <c:w val="0.8360067064981378"/>
          <c:h val="0.8204248295863803"/>
        </c:manualLayout>
      </c:layout>
      <c:areaChart>
        <c:grouping val="stacked"/>
        <c:varyColors val="0"/>
        <c:ser>
          <c:idx val="0"/>
          <c:order val="0"/>
          <c:tx>
            <c:strRef>
              <c:f>Sheet1!$E$10</c:f>
              <c:strCache>
                <c:ptCount val="1"/>
                <c:pt idx="0">
                  <c:v>LTR7</c:v>
                </c:pt>
              </c:strCache>
            </c:strRef>
          </c:tx>
          <c:spPr>
            <a:solidFill>
              <a:schemeClr val="accent1"/>
            </a:solidFill>
            <a:ln>
              <a:noFill/>
            </a:ln>
            <a:effectLst/>
          </c:spPr>
          <c:cat>
            <c:strRef>
              <c:f>Sheet1!$F$9:$P$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10:$P$10</c:f>
              <c:numCache>
                <c:formatCode>General</c:formatCode>
                <c:ptCount val="11"/>
                <c:pt idx="0">
                  <c:v>0</c:v>
                </c:pt>
                <c:pt idx="1">
                  <c:v>0.51668515376347957</c:v>
                </c:pt>
                <c:pt idx="2">
                  <c:v>-0.41836663258414042</c:v>
                </c:pt>
                <c:pt idx="3">
                  <c:v>-0.41836663258414042</c:v>
                </c:pt>
                <c:pt idx="4">
                  <c:v>-0.41836663258414042</c:v>
                </c:pt>
                <c:pt idx="5">
                  <c:v>-0.32529738606211023</c:v>
                </c:pt>
                <c:pt idx="6">
                  <c:v>8.001199468669995E-2</c:v>
                </c:pt>
                <c:pt idx="7">
                  <c:v>-0.30126540044401029</c:v>
                </c:pt>
                <c:pt idx="8">
                  <c:v>1.3836050916376594</c:v>
                </c:pt>
                <c:pt idx="9">
                  <c:v>5.9430955596768795</c:v>
                </c:pt>
                <c:pt idx="10">
                  <c:v>3.5142667718891198</c:v>
                </c:pt>
              </c:numCache>
            </c:numRef>
          </c:val>
        </c:ser>
        <c:ser>
          <c:idx val="1"/>
          <c:order val="1"/>
          <c:tx>
            <c:strRef>
              <c:f>Sheet1!$E$11</c:f>
              <c:strCache>
                <c:ptCount val="1"/>
                <c:pt idx="0">
                  <c:v>HERVH-int</c:v>
                </c:pt>
              </c:strCache>
            </c:strRef>
          </c:tx>
          <c:spPr>
            <a:solidFill>
              <a:schemeClr val="accent2"/>
            </a:solidFill>
            <a:ln>
              <a:noFill/>
            </a:ln>
            <a:effectLst/>
          </c:spPr>
          <c:cat>
            <c:strRef>
              <c:f>Sheet1!$F$9:$P$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11:$P$11</c:f>
              <c:numCache>
                <c:formatCode>General</c:formatCode>
                <c:ptCount val="11"/>
                <c:pt idx="0">
                  <c:v>0</c:v>
                </c:pt>
                <c:pt idx="1">
                  <c:v>0.89423704445582031</c:v>
                </c:pt>
                <c:pt idx="2">
                  <c:v>0.44514738489321992</c:v>
                </c:pt>
                <c:pt idx="3">
                  <c:v>0.99786871316495995</c:v>
                </c:pt>
                <c:pt idx="4">
                  <c:v>0.89363064158635019</c:v>
                </c:pt>
                <c:pt idx="5">
                  <c:v>0.10232111929733989</c:v>
                </c:pt>
                <c:pt idx="6">
                  <c:v>2.3944947144098001</c:v>
                </c:pt>
                <c:pt idx="7">
                  <c:v>0.24437283649330022</c:v>
                </c:pt>
                <c:pt idx="8">
                  <c:v>1.4780550221366799</c:v>
                </c:pt>
                <c:pt idx="9">
                  <c:v>8.3866056675281104</c:v>
                </c:pt>
                <c:pt idx="10">
                  <c:v>4.6462959293662021</c:v>
                </c:pt>
              </c:numCache>
            </c:numRef>
          </c:val>
        </c:ser>
        <c:ser>
          <c:idx val="2"/>
          <c:order val="2"/>
          <c:tx>
            <c:strRef>
              <c:f>Sheet1!$E$12</c:f>
              <c:strCache>
                <c:ptCount val="1"/>
                <c:pt idx="0">
                  <c:v>LTR7</c:v>
                </c:pt>
              </c:strCache>
            </c:strRef>
          </c:tx>
          <c:spPr>
            <a:solidFill>
              <a:schemeClr val="accent3"/>
            </a:solidFill>
            <a:ln>
              <a:noFill/>
            </a:ln>
            <a:effectLst/>
          </c:spPr>
          <c:cat>
            <c:strRef>
              <c:f>Sheet1!$F$9:$P$9</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12:$P$12</c:f>
              <c:numCache>
                <c:formatCode>General</c:formatCode>
                <c:ptCount val="11"/>
                <c:pt idx="0">
                  <c:v>0</c:v>
                </c:pt>
                <c:pt idx="1">
                  <c:v>0</c:v>
                </c:pt>
                <c:pt idx="2">
                  <c:v>0.59678897664027009</c:v>
                </c:pt>
                <c:pt idx="3">
                  <c:v>0.66054123464508008</c:v>
                </c:pt>
                <c:pt idx="4">
                  <c:v>0.41425877005</c:v>
                </c:pt>
                <c:pt idx="5">
                  <c:v>0</c:v>
                </c:pt>
                <c:pt idx="6">
                  <c:v>0.5263116054409096</c:v>
                </c:pt>
                <c:pt idx="7">
                  <c:v>0</c:v>
                </c:pt>
                <c:pt idx="8">
                  <c:v>2.55860656431692</c:v>
                </c:pt>
                <c:pt idx="9">
                  <c:v>9.0136404493386912</c:v>
                </c:pt>
                <c:pt idx="10">
                  <c:v>5.6078361877576004</c:v>
                </c:pt>
              </c:numCache>
            </c:numRef>
          </c:val>
        </c:ser>
        <c:dLbls>
          <c:showLegendKey val="0"/>
          <c:showVal val="0"/>
          <c:showCatName val="0"/>
          <c:showSerName val="0"/>
          <c:showPercent val="0"/>
          <c:showBubbleSize val="0"/>
        </c:dLbls>
        <c:axId val="309404744"/>
        <c:axId val="309402784"/>
      </c:areaChart>
      <c:catAx>
        <c:axId val="3094047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chemeClr val="tx1"/>
                </a:solidFill>
                <a:latin typeface="+mn-lt"/>
                <a:ea typeface="+mn-ea"/>
                <a:cs typeface="+mn-cs"/>
              </a:defRPr>
            </a:pPr>
            <a:endParaRPr lang="en-US"/>
          </a:p>
        </c:txPr>
        <c:crossAx val="309402784"/>
        <c:crosses val="autoZero"/>
        <c:auto val="1"/>
        <c:lblAlgn val="ctr"/>
        <c:lblOffset val="100"/>
        <c:noMultiLvlLbl val="0"/>
      </c:catAx>
      <c:valAx>
        <c:axId val="309402784"/>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2.0385889114244549E-2"/>
              <c:y val="0.3310221955093805"/>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4744"/>
        <c:crosses val="autoZero"/>
        <c:crossBetween val="midCat"/>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Dynamics of expression changes in the human embryos of the LTR7/HERVH loci associated with the HPAT15 lincRNA</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4329622582883608"/>
          <c:y val="0.14331344180655131"/>
          <c:w val="0.82033593433670715"/>
          <c:h val="0.77004949825969016"/>
        </c:manualLayout>
      </c:layout>
      <c:areaChart>
        <c:grouping val="stacked"/>
        <c:varyColors val="0"/>
        <c:ser>
          <c:idx val="0"/>
          <c:order val="0"/>
          <c:tx>
            <c:strRef>
              <c:f>Sheet1!$E$2</c:f>
              <c:strCache>
                <c:ptCount val="1"/>
                <c:pt idx="0">
                  <c:v>LTR7</c:v>
                </c:pt>
              </c:strCache>
            </c:strRef>
          </c:tx>
          <c:spPr>
            <a:solidFill>
              <a:schemeClr val="accent1"/>
            </a:solidFill>
            <a:ln>
              <a:noFill/>
            </a:ln>
            <a:effectLst/>
          </c:spPr>
          <c:cat>
            <c:strRef>
              <c:f>Sheet1!$F$1:$P$1</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2:$P$2</c:f>
              <c:numCache>
                <c:formatCode>General</c:formatCode>
                <c:ptCount val="11"/>
                <c:pt idx="0">
                  <c:v>0</c:v>
                </c:pt>
                <c:pt idx="1">
                  <c:v>0</c:v>
                </c:pt>
                <c:pt idx="2">
                  <c:v>0</c:v>
                </c:pt>
                <c:pt idx="3">
                  <c:v>0</c:v>
                </c:pt>
                <c:pt idx="4">
                  <c:v>0.2042371416808999</c:v>
                </c:pt>
                <c:pt idx="5">
                  <c:v>9.4039653237140364E-2</c:v>
                </c:pt>
                <c:pt idx="6">
                  <c:v>0.14470392093329032</c:v>
                </c:pt>
                <c:pt idx="7">
                  <c:v>1.44852816765522</c:v>
                </c:pt>
                <c:pt idx="8">
                  <c:v>2.65669729940221</c:v>
                </c:pt>
                <c:pt idx="9">
                  <c:v>5.7865747085669206</c:v>
                </c:pt>
                <c:pt idx="10">
                  <c:v>4.9966928540786339</c:v>
                </c:pt>
              </c:numCache>
            </c:numRef>
          </c:val>
        </c:ser>
        <c:ser>
          <c:idx val="1"/>
          <c:order val="1"/>
          <c:tx>
            <c:strRef>
              <c:f>Sheet1!$E$3</c:f>
              <c:strCache>
                <c:ptCount val="1"/>
                <c:pt idx="0">
                  <c:v>HERVH-int</c:v>
                </c:pt>
              </c:strCache>
            </c:strRef>
          </c:tx>
          <c:spPr>
            <a:solidFill>
              <a:schemeClr val="accent2"/>
            </a:solidFill>
            <a:ln>
              <a:noFill/>
            </a:ln>
            <a:effectLst/>
          </c:spPr>
          <c:cat>
            <c:strRef>
              <c:f>Sheet1!$F$1:$P$1</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3:$P$3</c:f>
              <c:numCache>
                <c:formatCode>General</c:formatCode>
                <c:ptCount val="11"/>
                <c:pt idx="0">
                  <c:v>0</c:v>
                </c:pt>
                <c:pt idx="1">
                  <c:v>1.1699567824494501</c:v>
                </c:pt>
                <c:pt idx="2">
                  <c:v>1.3111433366066119</c:v>
                </c:pt>
                <c:pt idx="3">
                  <c:v>0.88047502355042295</c:v>
                </c:pt>
                <c:pt idx="4">
                  <c:v>0.454999972508358</c:v>
                </c:pt>
                <c:pt idx="5">
                  <c:v>0.55302073785065153</c:v>
                </c:pt>
                <c:pt idx="6">
                  <c:v>-0.32609247543032804</c:v>
                </c:pt>
                <c:pt idx="7">
                  <c:v>1.1649327039509041</c:v>
                </c:pt>
                <c:pt idx="8">
                  <c:v>2.9555760576975749</c:v>
                </c:pt>
                <c:pt idx="9">
                  <c:v>4.7567047150018542</c:v>
                </c:pt>
                <c:pt idx="10">
                  <c:v>4.8562729143799857</c:v>
                </c:pt>
              </c:numCache>
            </c:numRef>
          </c:val>
        </c:ser>
        <c:ser>
          <c:idx val="2"/>
          <c:order val="2"/>
          <c:tx>
            <c:strRef>
              <c:f>Sheet1!$E$4</c:f>
              <c:strCache>
                <c:ptCount val="1"/>
                <c:pt idx="0">
                  <c:v>HERVH-int</c:v>
                </c:pt>
              </c:strCache>
            </c:strRef>
          </c:tx>
          <c:spPr>
            <a:solidFill>
              <a:schemeClr val="accent3"/>
            </a:solidFill>
            <a:ln>
              <a:noFill/>
            </a:ln>
            <a:effectLst/>
          </c:spPr>
          <c:cat>
            <c:strRef>
              <c:f>Sheet1!$F$1:$P$1</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4:$P$4</c:f>
              <c:numCache>
                <c:formatCode>General</c:formatCode>
                <c:ptCount val="11"/>
                <c:pt idx="0">
                  <c:v>0</c:v>
                </c:pt>
                <c:pt idx="1">
                  <c:v>1.5068760731872852</c:v>
                </c:pt>
                <c:pt idx="2">
                  <c:v>2.8196310817214343</c:v>
                </c:pt>
                <c:pt idx="3">
                  <c:v>1.5327549100962852</c:v>
                </c:pt>
                <c:pt idx="4">
                  <c:v>-0.72500602297395966</c:v>
                </c:pt>
                <c:pt idx="5">
                  <c:v>-0.72108399263665968</c:v>
                </c:pt>
                <c:pt idx="6">
                  <c:v>-1.3217041468464998</c:v>
                </c:pt>
                <c:pt idx="7">
                  <c:v>0.16379071606591999</c:v>
                </c:pt>
                <c:pt idx="8">
                  <c:v>2.4842543717947549</c:v>
                </c:pt>
                <c:pt idx="9">
                  <c:v>6.17016358898832</c:v>
                </c:pt>
                <c:pt idx="10">
                  <c:v>5.3412058399471807</c:v>
                </c:pt>
              </c:numCache>
            </c:numRef>
          </c:val>
        </c:ser>
        <c:ser>
          <c:idx val="3"/>
          <c:order val="3"/>
          <c:tx>
            <c:strRef>
              <c:f>Sheet1!$E$5</c:f>
              <c:strCache>
                <c:ptCount val="1"/>
                <c:pt idx="0">
                  <c:v>LTR7</c:v>
                </c:pt>
              </c:strCache>
            </c:strRef>
          </c:tx>
          <c:spPr>
            <a:solidFill>
              <a:schemeClr val="accent4"/>
            </a:solidFill>
            <a:ln>
              <a:noFill/>
            </a:ln>
            <a:effectLst/>
          </c:spPr>
          <c:cat>
            <c:strRef>
              <c:f>Sheet1!$F$1:$P$1</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1!$F$5:$P$5</c:f>
              <c:numCache>
                <c:formatCode>General</c:formatCode>
                <c:ptCount val="11"/>
                <c:pt idx="0">
                  <c:v>0</c:v>
                </c:pt>
                <c:pt idx="1">
                  <c:v>0.14889887885977027</c:v>
                </c:pt>
                <c:pt idx="2">
                  <c:v>2.2990860290785302</c:v>
                </c:pt>
                <c:pt idx="3">
                  <c:v>1.0640480932912402</c:v>
                </c:pt>
                <c:pt idx="4">
                  <c:v>-0.31218952786524001</c:v>
                </c:pt>
                <c:pt idx="5">
                  <c:v>-7.5333163243769707E-2</c:v>
                </c:pt>
                <c:pt idx="6">
                  <c:v>-0.48495158407530958</c:v>
                </c:pt>
                <c:pt idx="7">
                  <c:v>1.7193492213019101</c:v>
                </c:pt>
                <c:pt idx="8">
                  <c:v>1.7346917926108101</c:v>
                </c:pt>
                <c:pt idx="9">
                  <c:v>7.3266844931872708</c:v>
                </c:pt>
                <c:pt idx="10">
                  <c:v>6.3612427623032302</c:v>
                </c:pt>
              </c:numCache>
            </c:numRef>
          </c:val>
        </c:ser>
        <c:dLbls>
          <c:showLegendKey val="0"/>
          <c:showVal val="0"/>
          <c:showCatName val="0"/>
          <c:showSerName val="0"/>
          <c:showPercent val="0"/>
          <c:showBubbleSize val="0"/>
        </c:dLbls>
        <c:axId val="309400040"/>
        <c:axId val="309400432"/>
      </c:areaChart>
      <c:catAx>
        <c:axId val="3094000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0432"/>
        <c:crosses val="autoZero"/>
        <c:auto val="1"/>
        <c:lblAlgn val="ctr"/>
        <c:lblOffset val="100"/>
        <c:noMultiLvlLbl val="0"/>
      </c:catAx>
      <c:valAx>
        <c:axId val="309400432"/>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Relative</a:t>
                </a:r>
                <a:r>
                  <a:rPr lang="en-US" sz="1800" b="1" baseline="0">
                    <a:solidFill>
                      <a:sysClr val="windowText" lastClr="000000"/>
                    </a:solidFill>
                  </a:rPr>
                  <a:t> expression</a:t>
                </a:r>
                <a:endParaRPr lang="en-US" sz="1800" b="1">
                  <a:solidFill>
                    <a:sysClr val="windowText" lastClr="000000"/>
                  </a:solidFill>
                </a:endParaRPr>
              </a:p>
            </c:rich>
          </c:tx>
          <c:layout>
            <c:manualLayout>
              <c:xMode val="edge"/>
              <c:yMode val="edge"/>
              <c:x val="3.6796287464351818E-2"/>
              <c:y val="0.31398782975651557"/>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0040"/>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r>
              <a:rPr lang="en-US" sz="1800" b="1" baseline="0">
                <a:solidFill>
                  <a:sysClr val="windowText" lastClr="000000"/>
                </a:solidFill>
              </a:rPr>
              <a:t>Dynamics of expression changes in the human embryos of the LTR7/HERVH locus associated with the HPAT2 lincRNA</a:t>
            </a:r>
            <a:endParaRPr lang="en-US" sz="1800" b="1">
              <a:solidFill>
                <a:sysClr val="windowText" lastClr="000000"/>
              </a:solidFill>
            </a:endParaRPr>
          </a:p>
        </c:rich>
      </c:tx>
      <c:overlay val="0"/>
      <c:spPr>
        <a:noFill/>
        <a:ln>
          <a:noFill/>
        </a:ln>
        <a:effectLst/>
      </c:spPr>
      <c:txPr>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0376916183547334"/>
          <c:y val="0.22856047994072293"/>
          <c:w val="0.84773361360949118"/>
          <c:h val="0.68081127536328667"/>
        </c:manualLayout>
      </c:layout>
      <c:areaChart>
        <c:grouping val="stacked"/>
        <c:varyColors val="0"/>
        <c:ser>
          <c:idx val="0"/>
          <c:order val="0"/>
          <c:tx>
            <c:strRef>
              <c:f>Sheet3!$A$35</c:f>
              <c:strCache>
                <c:ptCount val="1"/>
                <c:pt idx="0">
                  <c:v>HERVH-int</c:v>
                </c:pt>
              </c:strCache>
            </c:strRef>
          </c:tx>
          <c:spPr>
            <a:solidFill>
              <a:schemeClr val="accent1"/>
            </a:solidFill>
            <a:ln>
              <a:noFill/>
            </a:ln>
            <a:effectLst/>
          </c:spPr>
          <c:cat>
            <c:strRef>
              <c:f>Sheet3!$B$34:$L$34</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35:$L$35</c:f>
              <c:numCache>
                <c:formatCode>General</c:formatCode>
                <c:ptCount val="11"/>
                <c:pt idx="0">
                  <c:v>0</c:v>
                </c:pt>
                <c:pt idx="1">
                  <c:v>0.73723536120345012</c:v>
                </c:pt>
                <c:pt idx="2">
                  <c:v>0.92816493130298006</c:v>
                </c:pt>
                <c:pt idx="3">
                  <c:v>0.82883081278754012</c:v>
                </c:pt>
                <c:pt idx="4">
                  <c:v>-6.6274247153309762E-2</c:v>
                </c:pt>
                <c:pt idx="5">
                  <c:v>-1.6598200998341599</c:v>
                </c:pt>
                <c:pt idx="6">
                  <c:v>-2.3793025784921</c:v>
                </c:pt>
                <c:pt idx="7">
                  <c:v>-2.3919075195442496</c:v>
                </c:pt>
                <c:pt idx="8">
                  <c:v>-2.4616707422122199</c:v>
                </c:pt>
                <c:pt idx="9">
                  <c:v>1.6141311895834312</c:v>
                </c:pt>
                <c:pt idx="10">
                  <c:v>2.0868718902749697</c:v>
                </c:pt>
              </c:numCache>
            </c:numRef>
          </c:val>
        </c:ser>
        <c:ser>
          <c:idx val="1"/>
          <c:order val="1"/>
          <c:tx>
            <c:strRef>
              <c:f>Sheet3!$A$36</c:f>
              <c:strCache>
                <c:ptCount val="1"/>
                <c:pt idx="0">
                  <c:v>LTR7</c:v>
                </c:pt>
              </c:strCache>
            </c:strRef>
          </c:tx>
          <c:spPr>
            <a:solidFill>
              <a:srgbClr val="FF0000"/>
            </a:solidFill>
            <a:ln>
              <a:noFill/>
            </a:ln>
            <a:effectLst/>
          </c:spPr>
          <c:cat>
            <c:strRef>
              <c:f>Sheet3!$B$34:$L$34</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36:$L$36</c:f>
              <c:numCache>
                <c:formatCode>General</c:formatCode>
                <c:ptCount val="11"/>
                <c:pt idx="0">
                  <c:v>0</c:v>
                </c:pt>
                <c:pt idx="1">
                  <c:v>-0.66033126349968985</c:v>
                </c:pt>
                <c:pt idx="2">
                  <c:v>-0.66033126349968985</c:v>
                </c:pt>
                <c:pt idx="3">
                  <c:v>0.57474505124287001</c:v>
                </c:pt>
                <c:pt idx="4">
                  <c:v>5.6632685510300096E-2</c:v>
                </c:pt>
                <c:pt idx="5">
                  <c:v>-0.41427658195348993</c:v>
                </c:pt>
                <c:pt idx="6">
                  <c:v>-0.66033126349968985</c:v>
                </c:pt>
                <c:pt idx="7">
                  <c:v>-0.66033126349968985</c:v>
                </c:pt>
                <c:pt idx="8">
                  <c:v>0.20601228032317032</c:v>
                </c:pt>
                <c:pt idx="9">
                  <c:v>4.6397979186002427</c:v>
                </c:pt>
                <c:pt idx="10">
                  <c:v>4.2610657430940666</c:v>
                </c:pt>
              </c:numCache>
            </c:numRef>
          </c:val>
        </c:ser>
        <c:dLbls>
          <c:showLegendKey val="0"/>
          <c:showVal val="0"/>
          <c:showCatName val="0"/>
          <c:showSerName val="0"/>
          <c:showPercent val="0"/>
          <c:showBubbleSize val="0"/>
        </c:dLbls>
        <c:dropLines>
          <c:spPr>
            <a:ln w="9525" cap="flat" cmpd="sng" algn="ctr">
              <a:solidFill>
                <a:schemeClr val="tx1">
                  <a:lumMod val="35000"/>
                  <a:lumOff val="65000"/>
                </a:schemeClr>
              </a:solidFill>
              <a:round/>
            </a:ln>
            <a:effectLst/>
          </c:spPr>
        </c:dropLines>
        <c:axId val="309399648"/>
        <c:axId val="309403568"/>
      </c:areaChart>
      <c:catAx>
        <c:axId val="309399648"/>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3568"/>
        <c:crosses val="autoZero"/>
        <c:auto val="1"/>
        <c:lblAlgn val="ctr"/>
        <c:lblOffset val="100"/>
        <c:noMultiLvlLbl val="0"/>
      </c:catAx>
      <c:valAx>
        <c:axId val="309403568"/>
        <c:scaling>
          <c:orientation val="minMax"/>
          <c:max val="6"/>
        </c:scaling>
        <c:delete val="0"/>
        <c:axPos val="l"/>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399648"/>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userShapes r:id="rId4"/>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r>
              <a:rPr lang="en-US" sz="1800" b="1" i="0" baseline="0">
                <a:effectLst/>
              </a:rPr>
              <a:t>Dynamics of expression changes in the human embryos of the TE loci associated with the HPAT5 lincRNA</a:t>
            </a:r>
            <a:endParaRPr lang="en-US">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lumMod val="65000"/>
                  <a:lumOff val="35000"/>
                </a:sysClr>
              </a:solidFill>
              <a:latin typeface="+mn-lt"/>
              <a:ea typeface="+mn-ea"/>
              <a:cs typeface="+mn-cs"/>
            </a:defRPr>
          </a:pPr>
          <a:endParaRPr lang="en-US"/>
        </a:p>
      </c:txPr>
    </c:title>
    <c:autoTitleDeleted val="0"/>
    <c:plotArea>
      <c:layout>
        <c:manualLayout>
          <c:layoutTarget val="inner"/>
          <c:xMode val="edge"/>
          <c:yMode val="edge"/>
          <c:x val="0.13288547936502954"/>
          <c:y val="0.19755354891232624"/>
          <c:w val="0.83327592996912669"/>
          <c:h val="0.71854650340032211"/>
        </c:manualLayout>
      </c:layout>
      <c:areaChart>
        <c:grouping val="stacked"/>
        <c:varyColors val="0"/>
        <c:ser>
          <c:idx val="0"/>
          <c:order val="0"/>
          <c:tx>
            <c:strRef>
              <c:f>Sheet1!$E$73</c:f>
              <c:strCache>
                <c:ptCount val="1"/>
                <c:pt idx="0">
                  <c:v>HUERS-P1-int</c:v>
                </c:pt>
              </c:strCache>
            </c:strRef>
          </c:tx>
          <c:spPr>
            <a:solidFill>
              <a:schemeClr val="accent1"/>
            </a:solidFill>
            <a:ln>
              <a:noFill/>
            </a:ln>
            <a:effectLst/>
          </c:spPr>
          <c:cat>
            <c:strRef>
              <c:f>Sheet1!$F$72:$O$72</c:f>
              <c:strCache>
                <c:ptCount val="10"/>
                <c:pt idx="0">
                  <c:v>oocyt.mean</c:v>
                </c:pt>
                <c:pt idx="1">
                  <c:v>pronu.mean</c:v>
                </c:pt>
                <c:pt idx="2">
                  <c:v>zygot.mean</c:v>
                </c:pt>
                <c:pt idx="3">
                  <c:v>2cell.mean</c:v>
                </c:pt>
                <c:pt idx="4">
                  <c:v>4cell.mean</c:v>
                </c:pt>
                <c:pt idx="5">
                  <c:v>8cell.mean</c:v>
                </c:pt>
                <c:pt idx="6">
                  <c:v>morul.mean</c:v>
                </c:pt>
                <c:pt idx="7">
                  <c:v>lateb.mean</c:v>
                </c:pt>
                <c:pt idx="8">
                  <c:v>hescp0.mean</c:v>
                </c:pt>
                <c:pt idx="9">
                  <c:v>hescp10.mean</c:v>
                </c:pt>
              </c:strCache>
            </c:strRef>
          </c:cat>
          <c:val>
            <c:numRef>
              <c:f>Sheet1!$F$73:$O$73</c:f>
              <c:numCache>
                <c:formatCode>General</c:formatCode>
                <c:ptCount val="10"/>
                <c:pt idx="0">
                  <c:v>0</c:v>
                </c:pt>
                <c:pt idx="1">
                  <c:v>0</c:v>
                </c:pt>
                <c:pt idx="2">
                  <c:v>0</c:v>
                </c:pt>
                <c:pt idx="3">
                  <c:v>0.62868301944748994</c:v>
                </c:pt>
                <c:pt idx="4">
                  <c:v>0.19916763429088036</c:v>
                </c:pt>
                <c:pt idx="5">
                  <c:v>3.3992637537820336E-2</c:v>
                </c:pt>
                <c:pt idx="6">
                  <c:v>0.12049616316086986</c:v>
                </c:pt>
                <c:pt idx="7">
                  <c:v>0.11162099706210959</c:v>
                </c:pt>
                <c:pt idx="8">
                  <c:v>7.9182205503080905</c:v>
                </c:pt>
                <c:pt idx="9">
                  <c:v>6.9144178586523104</c:v>
                </c:pt>
              </c:numCache>
            </c:numRef>
          </c:val>
        </c:ser>
        <c:ser>
          <c:idx val="1"/>
          <c:order val="1"/>
          <c:tx>
            <c:strRef>
              <c:f>Sheet1!$E$74</c:f>
              <c:strCache>
                <c:ptCount val="1"/>
                <c:pt idx="0">
                  <c:v>HUERS-P1-int</c:v>
                </c:pt>
              </c:strCache>
            </c:strRef>
          </c:tx>
          <c:spPr>
            <a:solidFill>
              <a:schemeClr val="accent2"/>
            </a:solidFill>
            <a:ln>
              <a:noFill/>
            </a:ln>
            <a:effectLst/>
          </c:spPr>
          <c:cat>
            <c:strRef>
              <c:f>Sheet1!$F$72:$O$72</c:f>
              <c:strCache>
                <c:ptCount val="10"/>
                <c:pt idx="0">
                  <c:v>oocyt.mean</c:v>
                </c:pt>
                <c:pt idx="1">
                  <c:v>pronu.mean</c:v>
                </c:pt>
                <c:pt idx="2">
                  <c:v>zygot.mean</c:v>
                </c:pt>
                <c:pt idx="3">
                  <c:v>2cell.mean</c:v>
                </c:pt>
                <c:pt idx="4">
                  <c:v>4cell.mean</c:v>
                </c:pt>
                <c:pt idx="5">
                  <c:v>8cell.mean</c:v>
                </c:pt>
                <c:pt idx="6">
                  <c:v>morul.mean</c:v>
                </c:pt>
                <c:pt idx="7">
                  <c:v>lateb.mean</c:v>
                </c:pt>
                <c:pt idx="8">
                  <c:v>hescp0.mean</c:v>
                </c:pt>
                <c:pt idx="9">
                  <c:v>hescp10.mean</c:v>
                </c:pt>
              </c:strCache>
            </c:strRef>
          </c:cat>
          <c:val>
            <c:numRef>
              <c:f>Sheet1!$F$74:$O$74</c:f>
              <c:numCache>
                <c:formatCode>General</c:formatCode>
                <c:ptCount val="10"/>
                <c:pt idx="0">
                  <c:v>0</c:v>
                </c:pt>
                <c:pt idx="1">
                  <c:v>0</c:v>
                </c:pt>
                <c:pt idx="2">
                  <c:v>0</c:v>
                </c:pt>
                <c:pt idx="3">
                  <c:v>0.24192878636652004</c:v>
                </c:pt>
                <c:pt idx="4">
                  <c:v>0.36059493299906986</c:v>
                </c:pt>
                <c:pt idx="5">
                  <c:v>0</c:v>
                </c:pt>
                <c:pt idx="6">
                  <c:v>0</c:v>
                </c:pt>
                <c:pt idx="7">
                  <c:v>7.068782038798016E-2</c:v>
                </c:pt>
                <c:pt idx="8">
                  <c:v>7.44964915793238</c:v>
                </c:pt>
                <c:pt idx="9">
                  <c:v>6.2456798510483402</c:v>
                </c:pt>
              </c:numCache>
            </c:numRef>
          </c:val>
        </c:ser>
        <c:ser>
          <c:idx val="2"/>
          <c:order val="2"/>
          <c:tx>
            <c:strRef>
              <c:f>Sheet1!$E$75</c:f>
              <c:strCache>
                <c:ptCount val="1"/>
                <c:pt idx="0">
                  <c:v>LTR8</c:v>
                </c:pt>
              </c:strCache>
            </c:strRef>
          </c:tx>
          <c:spPr>
            <a:solidFill>
              <a:schemeClr val="accent3"/>
            </a:solidFill>
            <a:ln>
              <a:noFill/>
            </a:ln>
            <a:effectLst/>
          </c:spPr>
          <c:cat>
            <c:strRef>
              <c:f>Sheet1!$F$72:$O$72</c:f>
              <c:strCache>
                <c:ptCount val="10"/>
                <c:pt idx="0">
                  <c:v>oocyt.mean</c:v>
                </c:pt>
                <c:pt idx="1">
                  <c:v>pronu.mean</c:v>
                </c:pt>
                <c:pt idx="2">
                  <c:v>zygot.mean</c:v>
                </c:pt>
                <c:pt idx="3">
                  <c:v>2cell.mean</c:v>
                </c:pt>
                <c:pt idx="4">
                  <c:v>4cell.mean</c:v>
                </c:pt>
                <c:pt idx="5">
                  <c:v>8cell.mean</c:v>
                </c:pt>
                <c:pt idx="6">
                  <c:v>morul.mean</c:v>
                </c:pt>
                <c:pt idx="7">
                  <c:v>lateb.mean</c:v>
                </c:pt>
                <c:pt idx="8">
                  <c:v>hescp0.mean</c:v>
                </c:pt>
                <c:pt idx="9">
                  <c:v>hescp10.mean</c:v>
                </c:pt>
              </c:strCache>
            </c:strRef>
          </c:cat>
          <c:val>
            <c:numRef>
              <c:f>Sheet1!$F$75:$O$75</c:f>
              <c:numCache>
                <c:formatCode>General</c:formatCode>
                <c:ptCount val="10"/>
                <c:pt idx="0">
                  <c:v>0</c:v>
                </c:pt>
                <c:pt idx="1">
                  <c:v>0</c:v>
                </c:pt>
                <c:pt idx="2">
                  <c:v>0.72947104029772003</c:v>
                </c:pt>
                <c:pt idx="3">
                  <c:v>0.31720530682891024</c:v>
                </c:pt>
                <c:pt idx="4">
                  <c:v>0.33622769247257978</c:v>
                </c:pt>
                <c:pt idx="5">
                  <c:v>0.26203507794275982</c:v>
                </c:pt>
                <c:pt idx="6">
                  <c:v>0</c:v>
                </c:pt>
                <c:pt idx="7">
                  <c:v>0.17005234476341968</c:v>
                </c:pt>
                <c:pt idx="8">
                  <c:v>9.1334118718519903</c:v>
                </c:pt>
                <c:pt idx="9">
                  <c:v>8.0167983232409092</c:v>
                </c:pt>
              </c:numCache>
            </c:numRef>
          </c:val>
        </c:ser>
        <c:ser>
          <c:idx val="3"/>
          <c:order val="3"/>
          <c:tx>
            <c:strRef>
              <c:f>Sheet1!$E$76</c:f>
              <c:strCache>
                <c:ptCount val="1"/>
                <c:pt idx="0">
                  <c:v>MER52C</c:v>
                </c:pt>
              </c:strCache>
            </c:strRef>
          </c:tx>
          <c:spPr>
            <a:solidFill>
              <a:schemeClr val="accent4"/>
            </a:solidFill>
            <a:ln>
              <a:noFill/>
            </a:ln>
            <a:effectLst/>
          </c:spPr>
          <c:cat>
            <c:strRef>
              <c:f>Sheet1!$F$72:$O$72</c:f>
              <c:strCache>
                <c:ptCount val="10"/>
                <c:pt idx="0">
                  <c:v>oocyt.mean</c:v>
                </c:pt>
                <c:pt idx="1">
                  <c:v>pronu.mean</c:v>
                </c:pt>
                <c:pt idx="2">
                  <c:v>zygot.mean</c:v>
                </c:pt>
                <c:pt idx="3">
                  <c:v>2cell.mean</c:v>
                </c:pt>
                <c:pt idx="4">
                  <c:v>4cell.mean</c:v>
                </c:pt>
                <c:pt idx="5">
                  <c:v>8cell.mean</c:v>
                </c:pt>
                <c:pt idx="6">
                  <c:v>morul.mean</c:v>
                </c:pt>
                <c:pt idx="7">
                  <c:v>lateb.mean</c:v>
                </c:pt>
                <c:pt idx="8">
                  <c:v>hescp0.mean</c:v>
                </c:pt>
                <c:pt idx="9">
                  <c:v>hescp10.mean</c:v>
                </c:pt>
              </c:strCache>
            </c:strRef>
          </c:cat>
          <c:val>
            <c:numRef>
              <c:f>Sheet1!$F$76:$O$76</c:f>
              <c:numCache>
                <c:formatCode>General</c:formatCode>
                <c:ptCount val="10"/>
                <c:pt idx="0">
                  <c:v>0</c:v>
                </c:pt>
                <c:pt idx="1">
                  <c:v>0</c:v>
                </c:pt>
                <c:pt idx="2">
                  <c:v>0</c:v>
                </c:pt>
                <c:pt idx="3">
                  <c:v>0.34947445486183959</c:v>
                </c:pt>
                <c:pt idx="4">
                  <c:v>0</c:v>
                </c:pt>
                <c:pt idx="5">
                  <c:v>0</c:v>
                </c:pt>
                <c:pt idx="6">
                  <c:v>0</c:v>
                </c:pt>
                <c:pt idx="7">
                  <c:v>0</c:v>
                </c:pt>
                <c:pt idx="8">
                  <c:v>6.61838107771226</c:v>
                </c:pt>
                <c:pt idx="9">
                  <c:v>4.4805641947976591</c:v>
                </c:pt>
              </c:numCache>
            </c:numRef>
          </c:val>
        </c:ser>
        <c:ser>
          <c:idx val="4"/>
          <c:order val="4"/>
          <c:tx>
            <c:strRef>
              <c:f>Sheet1!$E$77</c:f>
              <c:strCache>
                <c:ptCount val="1"/>
                <c:pt idx="0">
                  <c:v>MER4B</c:v>
                </c:pt>
              </c:strCache>
            </c:strRef>
          </c:tx>
          <c:spPr>
            <a:solidFill>
              <a:schemeClr val="accent5"/>
            </a:solidFill>
            <a:ln>
              <a:noFill/>
            </a:ln>
            <a:effectLst/>
          </c:spPr>
          <c:cat>
            <c:strRef>
              <c:f>Sheet1!$F$72:$O$72</c:f>
              <c:strCache>
                <c:ptCount val="10"/>
                <c:pt idx="0">
                  <c:v>oocyt.mean</c:v>
                </c:pt>
                <c:pt idx="1">
                  <c:v>pronu.mean</c:v>
                </c:pt>
                <c:pt idx="2">
                  <c:v>zygot.mean</c:v>
                </c:pt>
                <c:pt idx="3">
                  <c:v>2cell.mean</c:v>
                </c:pt>
                <c:pt idx="4">
                  <c:v>4cell.mean</c:v>
                </c:pt>
                <c:pt idx="5">
                  <c:v>8cell.mean</c:v>
                </c:pt>
                <c:pt idx="6">
                  <c:v>morul.mean</c:v>
                </c:pt>
                <c:pt idx="7">
                  <c:v>lateb.mean</c:v>
                </c:pt>
                <c:pt idx="8">
                  <c:v>hescp0.mean</c:v>
                </c:pt>
                <c:pt idx="9">
                  <c:v>hescp10.mean</c:v>
                </c:pt>
              </c:strCache>
            </c:strRef>
          </c:cat>
          <c:val>
            <c:numRef>
              <c:f>Sheet1!$F$77:$O$77</c:f>
              <c:numCache>
                <c:formatCode>General</c:formatCode>
                <c:ptCount val="10"/>
                <c:pt idx="0">
                  <c:v>0</c:v>
                </c:pt>
                <c:pt idx="1">
                  <c:v>4.7146423815074803</c:v>
                </c:pt>
                <c:pt idx="2">
                  <c:v>3.8000191954052389</c:v>
                </c:pt>
                <c:pt idx="3">
                  <c:v>2.290329586037366</c:v>
                </c:pt>
                <c:pt idx="4">
                  <c:v>1.2514314933733302</c:v>
                </c:pt>
                <c:pt idx="5">
                  <c:v>-1.2094983875448904</c:v>
                </c:pt>
                <c:pt idx="6">
                  <c:v>-1.56616735357788</c:v>
                </c:pt>
                <c:pt idx="7">
                  <c:v>-1.56616735357788</c:v>
                </c:pt>
                <c:pt idx="8">
                  <c:v>-1.56616735357788</c:v>
                </c:pt>
                <c:pt idx="9">
                  <c:v>-1.56616735357788</c:v>
                </c:pt>
              </c:numCache>
            </c:numRef>
          </c:val>
        </c:ser>
        <c:dLbls>
          <c:showLegendKey val="0"/>
          <c:showVal val="0"/>
          <c:showCatName val="0"/>
          <c:showSerName val="0"/>
          <c:showPercent val="0"/>
          <c:showBubbleSize val="0"/>
        </c:dLbls>
        <c:axId val="309398080"/>
        <c:axId val="309401216"/>
      </c:areaChart>
      <c:catAx>
        <c:axId val="3093980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1216"/>
        <c:crosses val="autoZero"/>
        <c:auto val="1"/>
        <c:lblAlgn val="ctr"/>
        <c:lblOffset val="100"/>
        <c:noMultiLvlLbl val="0"/>
      </c:catAx>
      <c:valAx>
        <c:axId val="309401216"/>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sysClr val="windowText" lastClr="000000"/>
                    </a:solidFill>
                    <a:latin typeface="+mn-lt"/>
                    <a:ea typeface="+mn-ea"/>
                    <a:cs typeface="+mn-cs"/>
                  </a:defRPr>
                </a:pPr>
                <a:r>
                  <a:rPr lang="en-US" sz="1800" b="1" i="0" baseline="0">
                    <a:solidFill>
                      <a:sysClr val="windowText" lastClr="000000"/>
                    </a:solidFill>
                    <a:effectLst/>
                  </a:rPr>
                  <a:t>RELATIVE EXPRESSION</a:t>
                </a:r>
                <a:endParaRPr lang="en-US">
                  <a:solidFill>
                    <a:sysClr val="windowText" lastClr="000000"/>
                  </a:solidFill>
                  <a:effectLst/>
                </a:endParaRPr>
              </a:p>
            </c:rich>
          </c:tx>
          <c:layout>
            <c:manualLayout>
              <c:xMode val="edge"/>
              <c:yMode val="edge"/>
              <c:x val="2.4755316236364584E-2"/>
              <c:y val="0.35729697842779023"/>
            </c:manualLayout>
          </c:layout>
          <c:overlay val="0"/>
          <c:spPr>
            <a:noFill/>
            <a:ln>
              <a:noFill/>
            </a:ln>
            <a:effectLst/>
          </c:spPr>
          <c:txPr>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398080"/>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dirty="0">
                <a:solidFill>
                  <a:sysClr val="windowText" lastClr="000000"/>
                </a:solidFill>
                <a:effectLst/>
              </a:rPr>
              <a:t>Dynamics of expression changes in the human embryos of the LTR7/HERVH loci associated with the HPAT3 </a:t>
            </a:r>
            <a:r>
              <a:rPr lang="en-US" sz="1800" b="1" i="0" baseline="0" dirty="0" err="1">
                <a:solidFill>
                  <a:sysClr val="windowText" lastClr="000000"/>
                </a:solidFill>
                <a:effectLst/>
              </a:rPr>
              <a:t>lincRNA</a:t>
            </a:r>
            <a:endParaRPr lang="en-US" dirty="0">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4041574655845285"/>
          <c:y val="0.14331344180655131"/>
          <c:w val="0.82574566277570349"/>
          <c:h val="0.79715587738169624"/>
        </c:manualLayout>
      </c:layout>
      <c:areaChart>
        <c:grouping val="stacked"/>
        <c:varyColors val="0"/>
        <c:ser>
          <c:idx val="0"/>
          <c:order val="0"/>
          <c:tx>
            <c:strRef>
              <c:f>Sheet3!$A$53</c:f>
              <c:strCache>
                <c:ptCount val="1"/>
                <c:pt idx="0">
                  <c:v>LTR7</c:v>
                </c:pt>
              </c:strCache>
            </c:strRef>
          </c:tx>
          <c:spPr>
            <a:solidFill>
              <a:schemeClr val="accent1"/>
            </a:solidFill>
            <a:ln>
              <a:noFill/>
            </a:ln>
            <a:effectLst/>
          </c:spPr>
          <c:cat>
            <c:strRef>
              <c:f>Sheet3!$B$52:$L$5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53:$L$53</c:f>
              <c:numCache>
                <c:formatCode>General</c:formatCode>
                <c:ptCount val="11"/>
                <c:pt idx="0">
                  <c:v>0</c:v>
                </c:pt>
                <c:pt idx="1">
                  <c:v>0</c:v>
                </c:pt>
                <c:pt idx="2">
                  <c:v>0.59972757169952029</c:v>
                </c:pt>
                <c:pt idx="3">
                  <c:v>0.34456147083700017</c:v>
                </c:pt>
                <c:pt idx="4">
                  <c:v>0</c:v>
                </c:pt>
                <c:pt idx="5">
                  <c:v>0.15662512075869017</c:v>
                </c:pt>
                <c:pt idx="6">
                  <c:v>0</c:v>
                </c:pt>
                <c:pt idx="7">
                  <c:v>0</c:v>
                </c:pt>
                <c:pt idx="8">
                  <c:v>3.1499147880928899</c:v>
                </c:pt>
                <c:pt idx="9">
                  <c:v>3.7918696220253842</c:v>
                </c:pt>
                <c:pt idx="10">
                  <c:v>0.43688664829505974</c:v>
                </c:pt>
              </c:numCache>
            </c:numRef>
          </c:val>
        </c:ser>
        <c:ser>
          <c:idx val="1"/>
          <c:order val="1"/>
          <c:tx>
            <c:strRef>
              <c:f>Sheet3!$A$54</c:f>
              <c:strCache>
                <c:ptCount val="1"/>
                <c:pt idx="0">
                  <c:v>LTR7</c:v>
                </c:pt>
              </c:strCache>
            </c:strRef>
          </c:tx>
          <c:spPr>
            <a:solidFill>
              <a:schemeClr val="accent2"/>
            </a:solidFill>
            <a:ln>
              <a:noFill/>
            </a:ln>
            <a:effectLst/>
          </c:spPr>
          <c:cat>
            <c:strRef>
              <c:f>Sheet3!$B$52:$L$5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54:$L$54</c:f>
              <c:numCache>
                <c:formatCode>General</c:formatCode>
                <c:ptCount val="11"/>
                <c:pt idx="0">
                  <c:v>0</c:v>
                </c:pt>
                <c:pt idx="1">
                  <c:v>0</c:v>
                </c:pt>
                <c:pt idx="2">
                  <c:v>0.59972757169952029</c:v>
                </c:pt>
                <c:pt idx="3">
                  <c:v>0.34456147083700017</c:v>
                </c:pt>
                <c:pt idx="4">
                  <c:v>0</c:v>
                </c:pt>
                <c:pt idx="5">
                  <c:v>0.15662512075869017</c:v>
                </c:pt>
                <c:pt idx="6">
                  <c:v>0</c:v>
                </c:pt>
                <c:pt idx="7">
                  <c:v>0</c:v>
                </c:pt>
                <c:pt idx="8">
                  <c:v>3.1499147880928899</c:v>
                </c:pt>
                <c:pt idx="9">
                  <c:v>3.7918696220253842</c:v>
                </c:pt>
                <c:pt idx="10">
                  <c:v>0.43688664829505974</c:v>
                </c:pt>
              </c:numCache>
            </c:numRef>
          </c:val>
        </c:ser>
        <c:ser>
          <c:idx val="2"/>
          <c:order val="2"/>
          <c:tx>
            <c:strRef>
              <c:f>Sheet3!$A$55</c:f>
              <c:strCache>
                <c:ptCount val="1"/>
                <c:pt idx="0">
                  <c:v>HERVH-int</c:v>
                </c:pt>
              </c:strCache>
            </c:strRef>
          </c:tx>
          <c:spPr>
            <a:solidFill>
              <a:schemeClr val="accent3"/>
            </a:solidFill>
            <a:ln>
              <a:noFill/>
            </a:ln>
            <a:effectLst/>
          </c:spPr>
          <c:cat>
            <c:strRef>
              <c:f>Sheet3!$B$52:$L$5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55:$L$55</c:f>
              <c:numCache>
                <c:formatCode>General</c:formatCode>
                <c:ptCount val="11"/>
                <c:pt idx="0">
                  <c:v>0</c:v>
                </c:pt>
                <c:pt idx="1">
                  <c:v>0.89699511441644963</c:v>
                </c:pt>
                <c:pt idx="2">
                  <c:v>2.7750278079089039</c:v>
                </c:pt>
                <c:pt idx="3">
                  <c:v>1.3621477858184896</c:v>
                </c:pt>
                <c:pt idx="4">
                  <c:v>1.0181199821276397</c:v>
                </c:pt>
                <c:pt idx="5">
                  <c:v>-3.6488380003560028E-2</c:v>
                </c:pt>
                <c:pt idx="6">
                  <c:v>-0.64550930521554983</c:v>
                </c:pt>
                <c:pt idx="7">
                  <c:v>-0.32845696926128021</c:v>
                </c:pt>
                <c:pt idx="8">
                  <c:v>3.1824717580117388</c:v>
                </c:pt>
                <c:pt idx="9">
                  <c:v>4.6401418995462249</c:v>
                </c:pt>
                <c:pt idx="10">
                  <c:v>0.48214872162264966</c:v>
                </c:pt>
              </c:numCache>
            </c:numRef>
          </c:val>
        </c:ser>
        <c:ser>
          <c:idx val="3"/>
          <c:order val="3"/>
          <c:tx>
            <c:strRef>
              <c:f>Sheet3!$A$56</c:f>
              <c:strCache>
                <c:ptCount val="1"/>
                <c:pt idx="0">
                  <c:v>LTR7</c:v>
                </c:pt>
              </c:strCache>
            </c:strRef>
          </c:tx>
          <c:spPr>
            <a:solidFill>
              <a:schemeClr val="accent4"/>
            </a:solidFill>
            <a:ln>
              <a:noFill/>
            </a:ln>
            <a:effectLst/>
          </c:spPr>
          <c:cat>
            <c:strRef>
              <c:f>Sheet3!$B$52:$L$5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56:$L$56</c:f>
              <c:numCache>
                <c:formatCode>General</c:formatCode>
                <c:ptCount val="11"/>
                <c:pt idx="0">
                  <c:v>0</c:v>
                </c:pt>
                <c:pt idx="1">
                  <c:v>0.93968206367474005</c:v>
                </c:pt>
                <c:pt idx="2">
                  <c:v>1.6817367221719501</c:v>
                </c:pt>
                <c:pt idx="3">
                  <c:v>0</c:v>
                </c:pt>
                <c:pt idx="4">
                  <c:v>0</c:v>
                </c:pt>
                <c:pt idx="5">
                  <c:v>0.80631279278681012</c:v>
                </c:pt>
                <c:pt idx="6">
                  <c:v>0.16624951160414003</c:v>
                </c:pt>
                <c:pt idx="7">
                  <c:v>0.43413373211437989</c:v>
                </c:pt>
                <c:pt idx="8">
                  <c:v>5.5953643866216503</c:v>
                </c:pt>
                <c:pt idx="9">
                  <c:v>6.6461062602739602</c:v>
                </c:pt>
                <c:pt idx="10">
                  <c:v>0.74507024865122018</c:v>
                </c:pt>
              </c:numCache>
            </c:numRef>
          </c:val>
        </c:ser>
        <c:ser>
          <c:idx val="4"/>
          <c:order val="4"/>
          <c:tx>
            <c:strRef>
              <c:f>Sheet3!$A$57</c:f>
              <c:strCache>
                <c:ptCount val="1"/>
                <c:pt idx="0">
                  <c:v>LTR7</c:v>
                </c:pt>
              </c:strCache>
            </c:strRef>
          </c:tx>
          <c:spPr>
            <a:solidFill>
              <a:schemeClr val="accent5"/>
            </a:solidFill>
            <a:ln>
              <a:noFill/>
            </a:ln>
            <a:effectLst/>
          </c:spPr>
          <c:cat>
            <c:strRef>
              <c:f>Sheet3!$B$52:$L$52</c:f>
              <c:strCache>
                <c:ptCount val="11"/>
                <c:pt idx="0">
                  <c:v>oocyt.mean</c:v>
                </c:pt>
                <c:pt idx="1">
                  <c:v>pronu.mean</c:v>
                </c:pt>
                <c:pt idx="2">
                  <c:v>zygot.mean</c:v>
                </c:pt>
                <c:pt idx="3">
                  <c:v>2cell.mean</c:v>
                </c:pt>
                <c:pt idx="4">
                  <c:v>4cell.mean</c:v>
                </c:pt>
                <c:pt idx="5">
                  <c:v>8cell.mean</c:v>
                </c:pt>
                <c:pt idx="6">
                  <c:v>morul.mean</c:v>
                </c:pt>
                <c:pt idx="7">
                  <c:v>lateb.mean</c:v>
                </c:pt>
                <c:pt idx="8">
                  <c:v>epi.mean</c:v>
                </c:pt>
                <c:pt idx="9">
                  <c:v>hescp0.mean</c:v>
                </c:pt>
                <c:pt idx="10">
                  <c:v>hescp10.mean</c:v>
                </c:pt>
              </c:strCache>
            </c:strRef>
          </c:cat>
          <c:val>
            <c:numRef>
              <c:f>Sheet3!$B$57:$L$57</c:f>
              <c:numCache>
                <c:formatCode>General</c:formatCode>
                <c:ptCount val="11"/>
                <c:pt idx="0">
                  <c:v>0</c:v>
                </c:pt>
                <c:pt idx="1">
                  <c:v>0.93968206367474005</c:v>
                </c:pt>
                <c:pt idx="2">
                  <c:v>1.6817367221719501</c:v>
                </c:pt>
                <c:pt idx="3">
                  <c:v>0</c:v>
                </c:pt>
                <c:pt idx="4">
                  <c:v>0</c:v>
                </c:pt>
                <c:pt idx="5">
                  <c:v>0.80631279278681012</c:v>
                </c:pt>
                <c:pt idx="6">
                  <c:v>0.16624951160414003</c:v>
                </c:pt>
                <c:pt idx="7">
                  <c:v>0.43413373211437989</c:v>
                </c:pt>
                <c:pt idx="8">
                  <c:v>5.5953643866216503</c:v>
                </c:pt>
                <c:pt idx="9">
                  <c:v>6.6461062602739602</c:v>
                </c:pt>
                <c:pt idx="10">
                  <c:v>0.74507024865122018</c:v>
                </c:pt>
              </c:numCache>
            </c:numRef>
          </c:val>
        </c:ser>
        <c:dLbls>
          <c:showLegendKey val="0"/>
          <c:showVal val="0"/>
          <c:showCatName val="0"/>
          <c:showSerName val="0"/>
          <c:showPercent val="0"/>
          <c:showBubbleSize val="0"/>
        </c:dLbls>
        <c:axId val="309401608"/>
        <c:axId val="309399256"/>
      </c:areaChart>
      <c:catAx>
        <c:axId val="309401608"/>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399256"/>
        <c:crosses val="autoZero"/>
        <c:auto val="1"/>
        <c:lblAlgn val="ctr"/>
        <c:lblOffset val="100"/>
        <c:noMultiLvlLbl val="0"/>
      </c:catAx>
      <c:valAx>
        <c:axId val="309399256"/>
        <c:scaling>
          <c:orientation val="minMax"/>
        </c:scaling>
        <c:delete val="0"/>
        <c:axPos val="l"/>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9401608"/>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userShapes r:id="rId4"/>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a:solidFill>
                  <a:sysClr val="windowText" lastClr="000000"/>
                </a:solidFill>
                <a:effectLst/>
              </a:rPr>
              <a:t>Single cell analysis of the HPAT21 expression in human embryos</a:t>
            </a:r>
            <a:endParaRPr lang="en-US">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0114226538914171"/>
          <c:y val="8.7438604190418046E-2"/>
          <c:w val="0.88273323733274733"/>
          <c:h val="0.70347235141379305"/>
        </c:manualLayout>
      </c:layout>
      <c:barChart>
        <c:barDir val="col"/>
        <c:grouping val="clustered"/>
        <c:varyColors val="0"/>
        <c:ser>
          <c:idx val="0"/>
          <c:order val="0"/>
          <c:tx>
            <c:strRef>
              <c:f>Sheet5!$D$26</c:f>
              <c:strCache>
                <c:ptCount val="1"/>
                <c:pt idx="0">
                  <c:v>HPAT21</c:v>
                </c:pt>
              </c:strCache>
            </c:strRef>
          </c:tx>
          <c:spPr>
            <a:solidFill>
              <a:schemeClr val="accent1"/>
            </a:solidFill>
            <a:ln>
              <a:solidFill>
                <a:schemeClr val="accent1"/>
              </a:solidFill>
            </a:ln>
            <a:effectLst/>
          </c:spPr>
          <c:invertIfNegative val="0"/>
          <c:cat>
            <c:strRef>
              <c:f>Sheet5!$E$25:$EV$25</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5!$E$26:$EV$26</c:f>
              <c:numCache>
                <c:formatCode>General</c:formatCode>
                <c:ptCount val="148"/>
                <c:pt idx="0">
                  <c:v>8.8700000000000001E-2</c:v>
                </c:pt>
                <c:pt idx="1">
                  <c:v>0.1176</c:v>
                </c:pt>
                <c:pt idx="2">
                  <c:v>6.0600000000000001E-2</c:v>
                </c:pt>
                <c:pt idx="3">
                  <c:v>0</c:v>
                </c:pt>
                <c:pt idx="4">
                  <c:v>8.0000000000000002E-3</c:v>
                </c:pt>
                <c:pt idx="5">
                  <c:v>5.4000000000000003E-3</c:v>
                </c:pt>
                <c:pt idx="6">
                  <c:v>0.1457</c:v>
                </c:pt>
                <c:pt idx="7">
                  <c:v>4.7699999999999999E-2</c:v>
                </c:pt>
                <c:pt idx="8">
                  <c:v>1.7500000000000002E-2</c:v>
                </c:pt>
                <c:pt idx="9">
                  <c:v>6.59E-2</c:v>
                </c:pt>
                <c:pt idx="10">
                  <c:v>6.2799999999999995E-2</c:v>
                </c:pt>
                <c:pt idx="11">
                  <c:v>6.7000000000000004E-2</c:v>
                </c:pt>
                <c:pt idx="12">
                  <c:v>3.5999999999999999E-3</c:v>
                </c:pt>
                <c:pt idx="13">
                  <c:v>0</c:v>
                </c:pt>
                <c:pt idx="14">
                  <c:v>0.1149</c:v>
                </c:pt>
                <c:pt idx="15">
                  <c:v>8.2699999999999996E-2</c:v>
                </c:pt>
                <c:pt idx="16">
                  <c:v>6.2899999999999998E-2</c:v>
                </c:pt>
                <c:pt idx="17">
                  <c:v>0.16700000000000001</c:v>
                </c:pt>
                <c:pt idx="18">
                  <c:v>8.4699999999999998E-2</c:v>
                </c:pt>
                <c:pt idx="19">
                  <c:v>6.3899999999999998E-2</c:v>
                </c:pt>
                <c:pt idx="20">
                  <c:v>2.3099999999999999E-2</c:v>
                </c:pt>
                <c:pt idx="21">
                  <c:v>1.37E-2</c:v>
                </c:pt>
                <c:pt idx="22">
                  <c:v>0</c:v>
                </c:pt>
                <c:pt idx="23">
                  <c:v>0.126</c:v>
                </c:pt>
                <c:pt idx="24">
                  <c:v>0.2414</c:v>
                </c:pt>
                <c:pt idx="25">
                  <c:v>9.8100000000000007E-2</c:v>
                </c:pt>
                <c:pt idx="26">
                  <c:v>3.2599999999999997E-2</c:v>
                </c:pt>
                <c:pt idx="27">
                  <c:v>9.1899999999999996E-2</c:v>
                </c:pt>
                <c:pt idx="28">
                  <c:v>0.1434</c:v>
                </c:pt>
                <c:pt idx="29">
                  <c:v>0.13830000000000001</c:v>
                </c:pt>
                <c:pt idx="30">
                  <c:v>0.15049999999999999</c:v>
                </c:pt>
                <c:pt idx="31">
                  <c:v>9.2499999999999999E-2</c:v>
                </c:pt>
                <c:pt idx="32">
                  <c:v>7.8200000000000006E-2</c:v>
                </c:pt>
                <c:pt idx="33">
                  <c:v>0.1812</c:v>
                </c:pt>
                <c:pt idx="34">
                  <c:v>0.10920000000000001</c:v>
                </c:pt>
                <c:pt idx="35">
                  <c:v>4.4000000000000003E-3</c:v>
                </c:pt>
                <c:pt idx="36">
                  <c:v>0</c:v>
                </c:pt>
                <c:pt idx="37">
                  <c:v>4.3E-3</c:v>
                </c:pt>
                <c:pt idx="38">
                  <c:v>0</c:v>
                </c:pt>
                <c:pt idx="39">
                  <c:v>0</c:v>
                </c:pt>
                <c:pt idx="40">
                  <c:v>5.7000000000000002E-3</c:v>
                </c:pt>
                <c:pt idx="41">
                  <c:v>5.1999999999999998E-3</c:v>
                </c:pt>
                <c:pt idx="42">
                  <c:v>1.8700000000000001E-2</c:v>
                </c:pt>
                <c:pt idx="43">
                  <c:v>1.06E-2</c:v>
                </c:pt>
                <c:pt idx="44">
                  <c:v>1.8200000000000001E-2</c:v>
                </c:pt>
                <c:pt idx="45">
                  <c:v>7.0000000000000007E-2</c:v>
                </c:pt>
                <c:pt idx="46">
                  <c:v>0.50929999999999997</c:v>
                </c:pt>
                <c:pt idx="47">
                  <c:v>0.154</c:v>
                </c:pt>
                <c:pt idx="48">
                  <c:v>3.4700000000000002E-2</c:v>
                </c:pt>
                <c:pt idx="49">
                  <c:v>3.8399999999999997E-2</c:v>
                </c:pt>
                <c:pt idx="50">
                  <c:v>1.0699999999999999E-2</c:v>
                </c:pt>
                <c:pt idx="51">
                  <c:v>8.0999999999999996E-3</c:v>
                </c:pt>
                <c:pt idx="52">
                  <c:v>6.6699999999999995E-2</c:v>
                </c:pt>
                <c:pt idx="53">
                  <c:v>7.0000000000000001E-3</c:v>
                </c:pt>
                <c:pt idx="54">
                  <c:v>8.0000000000000002E-3</c:v>
                </c:pt>
                <c:pt idx="55">
                  <c:v>7.1999999999999998E-3</c:v>
                </c:pt>
                <c:pt idx="56">
                  <c:v>1.03E-2</c:v>
                </c:pt>
                <c:pt idx="57">
                  <c:v>1.1900000000000001E-2</c:v>
                </c:pt>
                <c:pt idx="58">
                  <c:v>0</c:v>
                </c:pt>
                <c:pt idx="59">
                  <c:v>0</c:v>
                </c:pt>
                <c:pt idx="60">
                  <c:v>0</c:v>
                </c:pt>
                <c:pt idx="61">
                  <c:v>1.2200000000000001E-2</c:v>
                </c:pt>
                <c:pt idx="62">
                  <c:v>7.9000000000000008E-3</c:v>
                </c:pt>
                <c:pt idx="63">
                  <c:v>0</c:v>
                </c:pt>
                <c:pt idx="64">
                  <c:v>0</c:v>
                </c:pt>
                <c:pt idx="65">
                  <c:v>0.8407</c:v>
                </c:pt>
                <c:pt idx="66">
                  <c:v>0.1618</c:v>
                </c:pt>
                <c:pt idx="67">
                  <c:v>6.1999999999999998E-3</c:v>
                </c:pt>
                <c:pt idx="68">
                  <c:v>0.46650000000000003</c:v>
                </c:pt>
                <c:pt idx="69">
                  <c:v>4.5699999999999998E-2</c:v>
                </c:pt>
                <c:pt idx="70">
                  <c:v>0.10489999999999999</c:v>
                </c:pt>
                <c:pt idx="71">
                  <c:v>0.311</c:v>
                </c:pt>
                <c:pt idx="72">
                  <c:v>5.7999999999999996E-3</c:v>
                </c:pt>
                <c:pt idx="73">
                  <c:v>8.3699999999999997E-2</c:v>
                </c:pt>
                <c:pt idx="74">
                  <c:v>0.42180000000000001</c:v>
                </c:pt>
                <c:pt idx="75">
                  <c:v>2.0500000000000001E-2</c:v>
                </c:pt>
                <c:pt idx="76">
                  <c:v>2.0899999999999998E-2</c:v>
                </c:pt>
                <c:pt idx="77">
                  <c:v>0.21429999999999999</c:v>
                </c:pt>
                <c:pt idx="78">
                  <c:v>4.24E-2</c:v>
                </c:pt>
                <c:pt idx="79">
                  <c:v>0.29580000000000001</c:v>
                </c:pt>
                <c:pt idx="80">
                  <c:v>0.38119999999999998</c:v>
                </c:pt>
                <c:pt idx="81">
                  <c:v>0</c:v>
                </c:pt>
                <c:pt idx="82">
                  <c:v>2.63E-2</c:v>
                </c:pt>
                <c:pt idx="83">
                  <c:v>0.14050000000000001</c:v>
                </c:pt>
                <c:pt idx="84">
                  <c:v>2.3E-2</c:v>
                </c:pt>
                <c:pt idx="85">
                  <c:v>8.8400000000000006E-2</c:v>
                </c:pt>
                <c:pt idx="86">
                  <c:v>5.1999999999999998E-3</c:v>
                </c:pt>
                <c:pt idx="87">
                  <c:v>9.4000000000000004E-3</c:v>
                </c:pt>
                <c:pt idx="88">
                  <c:v>0</c:v>
                </c:pt>
                <c:pt idx="89">
                  <c:v>7.1000000000000004E-3</c:v>
                </c:pt>
                <c:pt idx="90">
                  <c:v>0.1799</c:v>
                </c:pt>
                <c:pt idx="91">
                  <c:v>2.4299999999999999E-2</c:v>
                </c:pt>
                <c:pt idx="92">
                  <c:v>0.23330000000000001</c:v>
                </c:pt>
                <c:pt idx="93">
                  <c:v>2.5600000000000001E-2</c:v>
                </c:pt>
                <c:pt idx="94">
                  <c:v>0.13339999999999999</c:v>
                </c:pt>
                <c:pt idx="95">
                  <c:v>2.3400000000000001E-2</c:v>
                </c:pt>
                <c:pt idx="96">
                  <c:v>1.7399999999999999E-2</c:v>
                </c:pt>
                <c:pt idx="97">
                  <c:v>3.6200000000000003E-2</c:v>
                </c:pt>
                <c:pt idx="98">
                  <c:v>2.98E-2</c:v>
                </c:pt>
                <c:pt idx="99">
                  <c:v>6.7999999999999996E-3</c:v>
                </c:pt>
                <c:pt idx="100">
                  <c:v>1.34E-2</c:v>
                </c:pt>
                <c:pt idx="101">
                  <c:v>0</c:v>
                </c:pt>
                <c:pt idx="102">
                  <c:v>9.2999999999999992E-3</c:v>
                </c:pt>
                <c:pt idx="103">
                  <c:v>7.6E-3</c:v>
                </c:pt>
                <c:pt idx="104">
                  <c:v>0</c:v>
                </c:pt>
                <c:pt idx="105">
                  <c:v>1.4800000000000001E-2</c:v>
                </c:pt>
                <c:pt idx="106">
                  <c:v>0</c:v>
                </c:pt>
                <c:pt idx="107">
                  <c:v>0</c:v>
                </c:pt>
                <c:pt idx="108">
                  <c:v>5.7000000000000002E-3</c:v>
                </c:pt>
                <c:pt idx="109">
                  <c:v>0.96730000000000005</c:v>
                </c:pt>
                <c:pt idx="110">
                  <c:v>0.65649999999999997</c:v>
                </c:pt>
                <c:pt idx="111">
                  <c:v>0</c:v>
                </c:pt>
                <c:pt idx="112">
                  <c:v>1.7500000000000002E-2</c:v>
                </c:pt>
                <c:pt idx="113">
                  <c:v>3.5999999999999999E-3</c:v>
                </c:pt>
                <c:pt idx="114">
                  <c:v>61.808</c:v>
                </c:pt>
                <c:pt idx="115">
                  <c:v>60.225200000000001</c:v>
                </c:pt>
                <c:pt idx="116">
                  <c:v>72.357200000000006</c:v>
                </c:pt>
                <c:pt idx="117">
                  <c:v>71.227099999999993</c:v>
                </c:pt>
                <c:pt idx="118">
                  <c:v>32.1937</c:v>
                </c:pt>
                <c:pt idx="119">
                  <c:v>72.267399999999995</c:v>
                </c:pt>
                <c:pt idx="120">
                  <c:v>53.044400000000003</c:v>
                </c:pt>
                <c:pt idx="121">
                  <c:v>4.109</c:v>
                </c:pt>
                <c:pt idx="122">
                  <c:v>11.230499999999999</c:v>
                </c:pt>
                <c:pt idx="123">
                  <c:v>24.081900000000001</c:v>
                </c:pt>
                <c:pt idx="124">
                  <c:v>7.0716000000000001</c:v>
                </c:pt>
                <c:pt idx="125">
                  <c:v>3.2814000000000001</c:v>
                </c:pt>
                <c:pt idx="126">
                  <c:v>18.6633</c:v>
                </c:pt>
                <c:pt idx="127">
                  <c:v>15.1158</c:v>
                </c:pt>
                <c:pt idx="128">
                  <c:v>3.5234000000000001</c:v>
                </c:pt>
                <c:pt idx="129">
                  <c:v>23.719000000000001</c:v>
                </c:pt>
                <c:pt idx="130">
                  <c:v>3.73E-2</c:v>
                </c:pt>
                <c:pt idx="131">
                  <c:v>1.0839000000000001</c:v>
                </c:pt>
                <c:pt idx="132">
                  <c:v>4.4299999999999999E-2</c:v>
                </c:pt>
                <c:pt idx="133">
                  <c:v>1.5145999999999999</c:v>
                </c:pt>
                <c:pt idx="134">
                  <c:v>1.1209</c:v>
                </c:pt>
                <c:pt idx="135">
                  <c:v>7.17E-2</c:v>
                </c:pt>
                <c:pt idx="136">
                  <c:v>10.473800000000001</c:v>
                </c:pt>
                <c:pt idx="137">
                  <c:v>11.7486</c:v>
                </c:pt>
                <c:pt idx="138">
                  <c:v>9.5899999999999999E-2</c:v>
                </c:pt>
                <c:pt idx="139">
                  <c:v>21.619599999999998</c:v>
                </c:pt>
                <c:pt idx="140">
                  <c:v>20.013999999999999</c:v>
                </c:pt>
                <c:pt idx="141">
                  <c:v>5.8999999999999999E-3</c:v>
                </c:pt>
                <c:pt idx="142">
                  <c:v>7.0190000000000001</c:v>
                </c:pt>
                <c:pt idx="143">
                  <c:v>1.9099999999999999E-2</c:v>
                </c:pt>
                <c:pt idx="144">
                  <c:v>22.5608</c:v>
                </c:pt>
                <c:pt idx="145">
                  <c:v>2.1899999999999999E-2</c:v>
                </c:pt>
                <c:pt idx="146">
                  <c:v>6.0199999999999997E-2</c:v>
                </c:pt>
                <c:pt idx="147">
                  <c:v>1.9099999999999999E-2</c:v>
                </c:pt>
              </c:numCache>
            </c:numRef>
          </c:val>
        </c:ser>
        <c:dLbls>
          <c:showLegendKey val="0"/>
          <c:showVal val="0"/>
          <c:showCatName val="0"/>
          <c:showSerName val="0"/>
          <c:showPercent val="0"/>
          <c:showBubbleSize val="0"/>
        </c:dLbls>
        <c:gapWidth val="150"/>
        <c:axId val="309402392"/>
        <c:axId val="309403176"/>
      </c:barChart>
      <c:catAx>
        <c:axId val="309402392"/>
        <c:scaling>
          <c:orientation val="minMax"/>
        </c:scaling>
        <c:delete val="0"/>
        <c:axPos val="b"/>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sysClr val="windowText" lastClr="000000"/>
                    </a:solidFill>
                    <a:latin typeface="+mn-lt"/>
                    <a:ea typeface="+mn-ea"/>
                    <a:cs typeface="+mn-cs"/>
                  </a:defRPr>
                </a:pPr>
                <a:r>
                  <a:rPr lang="en-US" sz="1400" b="1" i="0" baseline="0">
                    <a:solidFill>
                      <a:sysClr val="windowText" lastClr="000000"/>
                    </a:solidFill>
                    <a:effectLst/>
                  </a:rPr>
                  <a:t>EMBRYOGENESIS STAGE</a:t>
                </a:r>
                <a:endParaRPr lang="en-US" sz="1400">
                  <a:solidFill>
                    <a:sysClr val="windowText" lastClr="000000"/>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9403176"/>
        <c:crosses val="autoZero"/>
        <c:auto val="1"/>
        <c:lblAlgn val="ctr"/>
        <c:lblOffset val="100"/>
        <c:noMultiLvlLbl val="0"/>
      </c:catAx>
      <c:valAx>
        <c:axId val="309403176"/>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21</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2.0522087444868532E-2"/>
              <c:y val="0.31965874344700601"/>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0940239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chemeClr val="tx1"/>
                </a:solidFill>
                <a:latin typeface="+mn-lt"/>
                <a:ea typeface="+mn-ea"/>
                <a:cs typeface="+mn-cs"/>
              </a:defRPr>
            </a:pPr>
            <a:r>
              <a:rPr lang="en-US" sz="1800" b="1" i="0" baseline="0">
                <a:solidFill>
                  <a:schemeClr val="tx1"/>
                </a:solidFill>
                <a:effectLst/>
              </a:rPr>
              <a:t>Single cell analysis of the HPAT15 expression in human embryos</a:t>
            </a:r>
            <a:endParaRPr lang="en-US">
              <a:solidFill>
                <a:schemeClr val="tx1"/>
              </a:solidFill>
              <a:effectLst/>
            </a:endParaRPr>
          </a:p>
        </c:rich>
      </c:tx>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0139988799418641"/>
          <c:y val="7.4898197042188794E-2"/>
          <c:w val="0.88247561472770264"/>
          <c:h val="0.74277632288193396"/>
        </c:manualLayout>
      </c:layout>
      <c:barChart>
        <c:barDir val="col"/>
        <c:grouping val="clustered"/>
        <c:varyColors val="0"/>
        <c:ser>
          <c:idx val="0"/>
          <c:order val="0"/>
          <c:tx>
            <c:strRef>
              <c:f>Sheet5!$D$23</c:f>
              <c:strCache>
                <c:ptCount val="1"/>
                <c:pt idx="0">
                  <c:v>HPAT15</c:v>
                </c:pt>
              </c:strCache>
            </c:strRef>
          </c:tx>
          <c:spPr>
            <a:solidFill>
              <a:schemeClr val="accent1"/>
            </a:solidFill>
            <a:ln>
              <a:solidFill>
                <a:schemeClr val="accent1"/>
              </a:solidFill>
            </a:ln>
            <a:effectLst/>
          </c:spPr>
          <c:invertIfNegative val="0"/>
          <c:cat>
            <c:strRef>
              <c:f>Sheet5!$E$22:$EV$22</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5!$E$23:$EV$23</c:f>
              <c:numCache>
                <c:formatCode>General</c:formatCode>
                <c:ptCount val="148"/>
                <c:pt idx="0">
                  <c:v>0.27750000000000002</c:v>
                </c:pt>
                <c:pt idx="1">
                  <c:v>0.73509999999999998</c:v>
                </c:pt>
                <c:pt idx="2">
                  <c:v>1.2101</c:v>
                </c:pt>
                <c:pt idx="3">
                  <c:v>0</c:v>
                </c:pt>
                <c:pt idx="4">
                  <c:v>3.6200000000000003E-2</c:v>
                </c:pt>
                <c:pt idx="5">
                  <c:v>0</c:v>
                </c:pt>
                <c:pt idx="6">
                  <c:v>0.36030000000000001</c:v>
                </c:pt>
                <c:pt idx="7">
                  <c:v>0.7056</c:v>
                </c:pt>
                <c:pt idx="8">
                  <c:v>0.70269999999999999</c:v>
                </c:pt>
                <c:pt idx="9">
                  <c:v>0.39929999999999999</c:v>
                </c:pt>
                <c:pt idx="10">
                  <c:v>0.6391</c:v>
                </c:pt>
                <c:pt idx="11">
                  <c:v>0.79100000000000004</c:v>
                </c:pt>
                <c:pt idx="12">
                  <c:v>0.65180000000000005</c:v>
                </c:pt>
                <c:pt idx="13">
                  <c:v>0.39510000000000001</c:v>
                </c:pt>
                <c:pt idx="14">
                  <c:v>0.41649999999999998</c:v>
                </c:pt>
                <c:pt idx="15">
                  <c:v>0.56520000000000004</c:v>
                </c:pt>
                <c:pt idx="16">
                  <c:v>0.6169</c:v>
                </c:pt>
                <c:pt idx="17">
                  <c:v>0.64800000000000002</c:v>
                </c:pt>
                <c:pt idx="18">
                  <c:v>6.3899999999999998E-2</c:v>
                </c:pt>
                <c:pt idx="19">
                  <c:v>9.8599999999999993E-2</c:v>
                </c:pt>
                <c:pt idx="20">
                  <c:v>0.4219</c:v>
                </c:pt>
                <c:pt idx="21">
                  <c:v>0.41389999999999999</c:v>
                </c:pt>
                <c:pt idx="22">
                  <c:v>0.82230000000000003</c:v>
                </c:pt>
                <c:pt idx="23">
                  <c:v>0.95799999999999996</c:v>
                </c:pt>
                <c:pt idx="24">
                  <c:v>4.3E-3</c:v>
                </c:pt>
                <c:pt idx="25">
                  <c:v>1.23E-2</c:v>
                </c:pt>
                <c:pt idx="26">
                  <c:v>0</c:v>
                </c:pt>
                <c:pt idx="27">
                  <c:v>0.10059999999999999</c:v>
                </c:pt>
                <c:pt idx="28">
                  <c:v>0.49370000000000003</c:v>
                </c:pt>
                <c:pt idx="29">
                  <c:v>0.82220000000000004</c:v>
                </c:pt>
                <c:pt idx="30">
                  <c:v>5.57E-2</c:v>
                </c:pt>
                <c:pt idx="31">
                  <c:v>0.36780000000000002</c:v>
                </c:pt>
                <c:pt idx="32">
                  <c:v>1.6411</c:v>
                </c:pt>
                <c:pt idx="33">
                  <c:v>1.2849999999999999</c:v>
                </c:pt>
                <c:pt idx="34">
                  <c:v>0.64119999999999999</c:v>
                </c:pt>
                <c:pt idx="35">
                  <c:v>0.21820000000000001</c:v>
                </c:pt>
                <c:pt idx="36">
                  <c:v>1.8599999999999998E-2</c:v>
                </c:pt>
                <c:pt idx="37">
                  <c:v>0</c:v>
                </c:pt>
                <c:pt idx="38">
                  <c:v>0.19239999999999999</c:v>
                </c:pt>
                <c:pt idx="39">
                  <c:v>0.1158</c:v>
                </c:pt>
                <c:pt idx="40">
                  <c:v>0.14130000000000001</c:v>
                </c:pt>
                <c:pt idx="41">
                  <c:v>0.74839999999999995</c:v>
                </c:pt>
                <c:pt idx="42">
                  <c:v>5.6399999999999999E-2</c:v>
                </c:pt>
                <c:pt idx="43">
                  <c:v>2.9899999999999999E-2</c:v>
                </c:pt>
                <c:pt idx="44">
                  <c:v>2.06E-2</c:v>
                </c:pt>
                <c:pt idx="45">
                  <c:v>0.56059999999999999</c:v>
                </c:pt>
                <c:pt idx="46">
                  <c:v>0.4506</c:v>
                </c:pt>
                <c:pt idx="47">
                  <c:v>6.4512999999999998</c:v>
                </c:pt>
                <c:pt idx="48">
                  <c:v>2.0830000000000002</c:v>
                </c:pt>
                <c:pt idx="49">
                  <c:v>0.62609999999999999</c:v>
                </c:pt>
                <c:pt idx="50">
                  <c:v>4.0500000000000001E-2</c:v>
                </c:pt>
                <c:pt idx="51">
                  <c:v>1.38E-2</c:v>
                </c:pt>
                <c:pt idx="52">
                  <c:v>1.0800000000000001E-2</c:v>
                </c:pt>
                <c:pt idx="53">
                  <c:v>2.3900000000000001E-2</c:v>
                </c:pt>
                <c:pt idx="54">
                  <c:v>0.69440000000000002</c:v>
                </c:pt>
                <c:pt idx="55">
                  <c:v>8.2000000000000007E-3</c:v>
                </c:pt>
                <c:pt idx="56">
                  <c:v>5.7999999999999996E-3</c:v>
                </c:pt>
                <c:pt idx="57">
                  <c:v>1.7999999999999999E-2</c:v>
                </c:pt>
                <c:pt idx="58">
                  <c:v>0</c:v>
                </c:pt>
                <c:pt idx="59">
                  <c:v>1.0800000000000001E-2</c:v>
                </c:pt>
                <c:pt idx="60">
                  <c:v>6.2399999999999997E-2</c:v>
                </c:pt>
                <c:pt idx="61">
                  <c:v>9.1999999999999998E-3</c:v>
                </c:pt>
                <c:pt idx="62">
                  <c:v>8.9999999999999993E-3</c:v>
                </c:pt>
                <c:pt idx="63">
                  <c:v>0</c:v>
                </c:pt>
                <c:pt idx="64">
                  <c:v>5.62E-2</c:v>
                </c:pt>
                <c:pt idx="65">
                  <c:v>0.40129999999999999</c:v>
                </c:pt>
                <c:pt idx="66">
                  <c:v>6.0999999999999999E-2</c:v>
                </c:pt>
                <c:pt idx="67">
                  <c:v>0</c:v>
                </c:pt>
                <c:pt idx="68">
                  <c:v>2.4899999999999999E-2</c:v>
                </c:pt>
                <c:pt idx="69">
                  <c:v>1.72E-2</c:v>
                </c:pt>
                <c:pt idx="70">
                  <c:v>1.9800000000000002E-2</c:v>
                </c:pt>
                <c:pt idx="71">
                  <c:v>2.4E-2</c:v>
                </c:pt>
                <c:pt idx="72">
                  <c:v>6.6E-3</c:v>
                </c:pt>
                <c:pt idx="73">
                  <c:v>0.01</c:v>
                </c:pt>
                <c:pt idx="74">
                  <c:v>2.1000000000000001E-2</c:v>
                </c:pt>
                <c:pt idx="75">
                  <c:v>7.7000000000000002E-3</c:v>
                </c:pt>
                <c:pt idx="76">
                  <c:v>4.7000000000000002E-3</c:v>
                </c:pt>
                <c:pt idx="77">
                  <c:v>5.7999999999999996E-3</c:v>
                </c:pt>
                <c:pt idx="78">
                  <c:v>0.1067</c:v>
                </c:pt>
                <c:pt idx="79">
                  <c:v>9.4600000000000004E-2</c:v>
                </c:pt>
                <c:pt idx="80">
                  <c:v>2.63E-2</c:v>
                </c:pt>
                <c:pt idx="81">
                  <c:v>0.1484</c:v>
                </c:pt>
                <c:pt idx="82">
                  <c:v>0.16650000000000001</c:v>
                </c:pt>
                <c:pt idx="83">
                  <c:v>0.24729999999999999</c:v>
                </c:pt>
                <c:pt idx="84">
                  <c:v>3.9100000000000003E-2</c:v>
                </c:pt>
                <c:pt idx="85">
                  <c:v>2.3454000000000002</c:v>
                </c:pt>
                <c:pt idx="86">
                  <c:v>0.61929999999999996</c:v>
                </c:pt>
                <c:pt idx="87">
                  <c:v>0.56179999999999997</c:v>
                </c:pt>
                <c:pt idx="88">
                  <c:v>5.7290999999999999</c:v>
                </c:pt>
                <c:pt idx="89">
                  <c:v>1.5122</c:v>
                </c:pt>
                <c:pt idx="90">
                  <c:v>0.78390000000000004</c:v>
                </c:pt>
                <c:pt idx="91">
                  <c:v>1.8517999999999999</c:v>
                </c:pt>
                <c:pt idx="92">
                  <c:v>1.9481999999999999</c:v>
                </c:pt>
                <c:pt idx="93">
                  <c:v>5.1383999999999999</c:v>
                </c:pt>
                <c:pt idx="94">
                  <c:v>0.65720000000000001</c:v>
                </c:pt>
                <c:pt idx="95">
                  <c:v>2.6595</c:v>
                </c:pt>
                <c:pt idx="96">
                  <c:v>2.6606000000000001</c:v>
                </c:pt>
                <c:pt idx="97">
                  <c:v>23.926300000000001</c:v>
                </c:pt>
                <c:pt idx="98">
                  <c:v>6.8464999999999998</c:v>
                </c:pt>
                <c:pt idx="99">
                  <c:v>3.4316</c:v>
                </c:pt>
                <c:pt idx="100">
                  <c:v>4.4816000000000003</c:v>
                </c:pt>
                <c:pt idx="101">
                  <c:v>1.7919</c:v>
                </c:pt>
                <c:pt idx="102">
                  <c:v>7.5549999999999997</c:v>
                </c:pt>
                <c:pt idx="103">
                  <c:v>0.155</c:v>
                </c:pt>
                <c:pt idx="104">
                  <c:v>0.183</c:v>
                </c:pt>
                <c:pt idx="105">
                  <c:v>0.24049999999999999</c:v>
                </c:pt>
                <c:pt idx="106">
                  <c:v>1.1900000000000001E-2</c:v>
                </c:pt>
                <c:pt idx="107">
                  <c:v>1.4314</c:v>
                </c:pt>
                <c:pt idx="108">
                  <c:v>0</c:v>
                </c:pt>
                <c:pt idx="109">
                  <c:v>14.8329</c:v>
                </c:pt>
                <c:pt idx="110">
                  <c:v>2.1332</c:v>
                </c:pt>
                <c:pt idx="111">
                  <c:v>4.1399999999999999E-2</c:v>
                </c:pt>
                <c:pt idx="112">
                  <c:v>3.4599999999999999E-2</c:v>
                </c:pt>
                <c:pt idx="113">
                  <c:v>7.3700000000000002E-2</c:v>
                </c:pt>
                <c:pt idx="114">
                  <c:v>24.831</c:v>
                </c:pt>
                <c:pt idx="115">
                  <c:v>30.8704</c:v>
                </c:pt>
                <c:pt idx="116">
                  <c:v>39.087499999999999</c:v>
                </c:pt>
                <c:pt idx="117">
                  <c:v>27.957699999999999</c:v>
                </c:pt>
                <c:pt idx="118">
                  <c:v>30.35</c:v>
                </c:pt>
                <c:pt idx="119">
                  <c:v>29.0806</c:v>
                </c:pt>
                <c:pt idx="120">
                  <c:v>20.734100000000002</c:v>
                </c:pt>
                <c:pt idx="121">
                  <c:v>33.135800000000003</c:v>
                </c:pt>
                <c:pt idx="122">
                  <c:v>41.269399999999997</c:v>
                </c:pt>
                <c:pt idx="123">
                  <c:v>50.302100000000003</c:v>
                </c:pt>
                <c:pt idx="124">
                  <c:v>46.170400000000001</c:v>
                </c:pt>
                <c:pt idx="125">
                  <c:v>33.095799999999997</c:v>
                </c:pt>
                <c:pt idx="126">
                  <c:v>32.5015</c:v>
                </c:pt>
                <c:pt idx="127">
                  <c:v>34.335500000000003</c:v>
                </c:pt>
                <c:pt idx="128">
                  <c:v>26.6999</c:v>
                </c:pt>
                <c:pt idx="129">
                  <c:v>28</c:v>
                </c:pt>
                <c:pt idx="130">
                  <c:v>9.9586000000000006</c:v>
                </c:pt>
                <c:pt idx="131">
                  <c:v>26.107399999999998</c:v>
                </c:pt>
                <c:pt idx="132">
                  <c:v>19.778099999999998</c:v>
                </c:pt>
                <c:pt idx="133">
                  <c:v>14.23</c:v>
                </c:pt>
                <c:pt idx="134">
                  <c:v>33.730400000000003</c:v>
                </c:pt>
                <c:pt idx="135">
                  <c:v>52.984000000000002</c:v>
                </c:pt>
                <c:pt idx="136">
                  <c:v>39.127200000000002</c:v>
                </c:pt>
                <c:pt idx="137">
                  <c:v>22.563500000000001</c:v>
                </c:pt>
                <c:pt idx="138">
                  <c:v>23.561</c:v>
                </c:pt>
                <c:pt idx="139">
                  <c:v>62.685000000000002</c:v>
                </c:pt>
                <c:pt idx="140">
                  <c:v>26.522099999999998</c:v>
                </c:pt>
                <c:pt idx="141">
                  <c:v>30.3841</c:v>
                </c:pt>
                <c:pt idx="142">
                  <c:v>30.819400000000002</c:v>
                </c:pt>
                <c:pt idx="143">
                  <c:v>13.851800000000001</c:v>
                </c:pt>
                <c:pt idx="144">
                  <c:v>32.617899999999999</c:v>
                </c:pt>
                <c:pt idx="145">
                  <c:v>16.6083</c:v>
                </c:pt>
                <c:pt idx="146">
                  <c:v>38.199599999999997</c:v>
                </c:pt>
                <c:pt idx="147">
                  <c:v>9.9754000000000005</c:v>
                </c:pt>
              </c:numCache>
            </c:numRef>
          </c:val>
        </c:ser>
        <c:dLbls>
          <c:showLegendKey val="0"/>
          <c:showVal val="0"/>
          <c:showCatName val="0"/>
          <c:showSerName val="0"/>
          <c:showPercent val="0"/>
          <c:showBubbleSize val="0"/>
        </c:dLbls>
        <c:gapWidth val="150"/>
        <c:axId val="356492376"/>
        <c:axId val="356491984"/>
      </c:barChart>
      <c:catAx>
        <c:axId val="356492376"/>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56491984"/>
        <c:crosses val="autoZero"/>
        <c:auto val="1"/>
        <c:lblAlgn val="ctr"/>
        <c:lblOffset val="100"/>
        <c:noMultiLvlLbl val="0"/>
      </c:catAx>
      <c:valAx>
        <c:axId val="356491984"/>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a:t>
                </a:r>
                <a:r>
                  <a:rPr lang="en-US" sz="1400" b="1" baseline="0">
                    <a:solidFill>
                      <a:sysClr val="windowText" lastClr="000000"/>
                    </a:solidFill>
                  </a:rPr>
                  <a:t>15 EXPRESSION</a:t>
                </a:r>
                <a:endParaRPr lang="en-US" sz="1400" b="1">
                  <a:solidFill>
                    <a:sysClr val="windowText" lastClr="000000"/>
                  </a:solidFill>
                </a:endParaRPr>
              </a:p>
            </c:rich>
          </c:tx>
          <c:layout>
            <c:manualLayout>
              <c:xMode val="edge"/>
              <c:yMode val="edge"/>
              <c:x val="1.0687298328361709E-2"/>
              <c:y val="0.33484769705093409"/>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5649237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r>
              <a:rPr lang="en-US" sz="1800" b="1">
                <a:solidFill>
                  <a:sysClr val="windowText" lastClr="000000"/>
                </a:solidFill>
              </a:rPr>
              <a:t>Single cell analysis of the HPAT2 expression</a:t>
            </a:r>
            <a:r>
              <a:rPr lang="en-US" sz="1800" b="1" baseline="0">
                <a:solidFill>
                  <a:sysClr val="windowText" lastClr="000000"/>
                </a:solidFill>
              </a:rPr>
              <a:t> in human embryos</a:t>
            </a:r>
            <a:endParaRPr lang="en-US" sz="1800" b="1">
              <a:solidFill>
                <a:sysClr val="windowText" lastClr="000000"/>
              </a:solidFill>
            </a:endParaRPr>
          </a:p>
        </c:rich>
      </c:tx>
      <c:overlay val="0"/>
      <c:spPr>
        <a:noFill/>
        <a:ln>
          <a:noFill/>
        </a:ln>
        <a:effectLst/>
      </c:spPr>
      <c:txPr>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1459265849445904"/>
          <c:y val="0.12109137858933935"/>
          <c:w val="0.86928284422742996"/>
          <c:h val="0.6965831413347835"/>
        </c:manualLayout>
      </c:layout>
      <c:barChart>
        <c:barDir val="col"/>
        <c:grouping val="clustered"/>
        <c:varyColors val="0"/>
        <c:ser>
          <c:idx val="0"/>
          <c:order val="0"/>
          <c:tx>
            <c:strRef>
              <c:f>Sheet9!$A$13</c:f>
              <c:strCache>
                <c:ptCount val="1"/>
                <c:pt idx="0">
                  <c:v>HPAT2</c:v>
                </c:pt>
              </c:strCache>
            </c:strRef>
          </c:tx>
          <c:spPr>
            <a:solidFill>
              <a:srgbClr val="0070C0"/>
            </a:solidFill>
            <a:ln>
              <a:solidFill>
                <a:schemeClr val="accent1"/>
              </a:solidFill>
            </a:ln>
            <a:effectLst/>
          </c:spPr>
          <c:invertIfNegative val="0"/>
          <c:cat>
            <c:strRef>
              <c:f>Sheet9!$B$12:$ES$12</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9!$B$13:$ES$13</c:f>
              <c:numCache>
                <c:formatCode>General</c:formatCode>
                <c:ptCount val="148"/>
                <c:pt idx="0">
                  <c:v>0.13469999999999999</c:v>
                </c:pt>
                <c:pt idx="1">
                  <c:v>0.1338</c:v>
                </c:pt>
                <c:pt idx="2">
                  <c:v>0.2122</c:v>
                </c:pt>
                <c:pt idx="3">
                  <c:v>1.3100000000000001E-2</c:v>
                </c:pt>
                <c:pt idx="4">
                  <c:v>0.71499999999999997</c:v>
                </c:pt>
                <c:pt idx="5">
                  <c:v>0.11360000000000001</c:v>
                </c:pt>
                <c:pt idx="6">
                  <c:v>6.4799999999999996E-2</c:v>
                </c:pt>
                <c:pt idx="7">
                  <c:v>0.38350000000000001</c:v>
                </c:pt>
                <c:pt idx="8">
                  <c:v>0.18010000000000001</c:v>
                </c:pt>
                <c:pt idx="9">
                  <c:v>0.2429</c:v>
                </c:pt>
                <c:pt idx="10">
                  <c:v>0.19</c:v>
                </c:pt>
                <c:pt idx="11">
                  <c:v>0.2361</c:v>
                </c:pt>
                <c:pt idx="12">
                  <c:v>0.3044</c:v>
                </c:pt>
                <c:pt idx="13">
                  <c:v>8.7400000000000005E-2</c:v>
                </c:pt>
                <c:pt idx="14">
                  <c:v>0.2228</c:v>
                </c:pt>
                <c:pt idx="15">
                  <c:v>0.34160000000000001</c:v>
                </c:pt>
                <c:pt idx="16">
                  <c:v>0.15029999999999999</c:v>
                </c:pt>
                <c:pt idx="17">
                  <c:v>0.2034</c:v>
                </c:pt>
                <c:pt idx="18">
                  <c:v>0.1787</c:v>
                </c:pt>
                <c:pt idx="19">
                  <c:v>0.11940000000000001</c:v>
                </c:pt>
                <c:pt idx="20">
                  <c:v>0.63939999999999997</c:v>
                </c:pt>
                <c:pt idx="21">
                  <c:v>0.2054</c:v>
                </c:pt>
                <c:pt idx="22">
                  <c:v>1.26E-2</c:v>
                </c:pt>
                <c:pt idx="23">
                  <c:v>8.3599999999999994E-2</c:v>
                </c:pt>
                <c:pt idx="24">
                  <c:v>6.8500000000000005E-2</c:v>
                </c:pt>
                <c:pt idx="25">
                  <c:v>1.3899999999999999E-2</c:v>
                </c:pt>
                <c:pt idx="26">
                  <c:v>4.6699999999999998E-2</c:v>
                </c:pt>
                <c:pt idx="27">
                  <c:v>0.1303</c:v>
                </c:pt>
                <c:pt idx="28">
                  <c:v>7.9200000000000007E-2</c:v>
                </c:pt>
                <c:pt idx="29">
                  <c:v>0.28470000000000001</c:v>
                </c:pt>
                <c:pt idx="30">
                  <c:v>2.8799999999999999E-2</c:v>
                </c:pt>
                <c:pt idx="31">
                  <c:v>0.1066</c:v>
                </c:pt>
                <c:pt idx="32">
                  <c:v>0.1714</c:v>
                </c:pt>
                <c:pt idx="33">
                  <c:v>9.7199999999999995E-2</c:v>
                </c:pt>
                <c:pt idx="34">
                  <c:v>0.31319999999999998</c:v>
                </c:pt>
                <c:pt idx="35">
                  <c:v>8.3999999999999995E-3</c:v>
                </c:pt>
                <c:pt idx="36">
                  <c:v>1.0218</c:v>
                </c:pt>
                <c:pt idx="37">
                  <c:v>0</c:v>
                </c:pt>
                <c:pt idx="38">
                  <c:v>9.4799999999999995E-2</c:v>
                </c:pt>
                <c:pt idx="39">
                  <c:v>5.1000000000000004E-3</c:v>
                </c:pt>
                <c:pt idx="40">
                  <c:v>1.09E-2</c:v>
                </c:pt>
                <c:pt idx="41">
                  <c:v>9.9000000000000008E-3</c:v>
                </c:pt>
                <c:pt idx="42">
                  <c:v>0</c:v>
                </c:pt>
                <c:pt idx="43">
                  <c:v>5.1000000000000004E-3</c:v>
                </c:pt>
                <c:pt idx="44">
                  <c:v>8.14E-2</c:v>
                </c:pt>
                <c:pt idx="45">
                  <c:v>1.54E-2</c:v>
                </c:pt>
                <c:pt idx="46">
                  <c:v>3.3700000000000001E-2</c:v>
                </c:pt>
                <c:pt idx="47">
                  <c:v>0.25879999999999997</c:v>
                </c:pt>
                <c:pt idx="48">
                  <c:v>0.2407</c:v>
                </c:pt>
                <c:pt idx="49">
                  <c:v>0.1249</c:v>
                </c:pt>
                <c:pt idx="50">
                  <c:v>0</c:v>
                </c:pt>
                <c:pt idx="51">
                  <c:v>0</c:v>
                </c:pt>
                <c:pt idx="52">
                  <c:v>4.5999999999999999E-3</c:v>
                </c:pt>
                <c:pt idx="53">
                  <c:v>0.52100000000000002</c:v>
                </c:pt>
                <c:pt idx="54">
                  <c:v>3.8E-3</c:v>
                </c:pt>
                <c:pt idx="55">
                  <c:v>0</c:v>
                </c:pt>
                <c:pt idx="56">
                  <c:v>9.7999999999999997E-3</c:v>
                </c:pt>
                <c:pt idx="57">
                  <c:v>1.14E-2</c:v>
                </c:pt>
                <c:pt idx="58">
                  <c:v>0</c:v>
                </c:pt>
                <c:pt idx="59">
                  <c:v>0</c:v>
                </c:pt>
                <c:pt idx="60">
                  <c:v>0.31190000000000001</c:v>
                </c:pt>
                <c:pt idx="61">
                  <c:v>0</c:v>
                </c:pt>
                <c:pt idx="62">
                  <c:v>0</c:v>
                </c:pt>
                <c:pt idx="63">
                  <c:v>0</c:v>
                </c:pt>
                <c:pt idx="64">
                  <c:v>7.9000000000000008E-3</c:v>
                </c:pt>
                <c:pt idx="65">
                  <c:v>7.4000000000000003E-3</c:v>
                </c:pt>
                <c:pt idx="66">
                  <c:v>0</c:v>
                </c:pt>
                <c:pt idx="67">
                  <c:v>1.18E-2</c:v>
                </c:pt>
                <c:pt idx="68">
                  <c:v>4.1999999999999997E-3</c:v>
                </c:pt>
                <c:pt idx="69">
                  <c:v>1.4500000000000001E-2</c:v>
                </c:pt>
                <c:pt idx="70">
                  <c:v>0</c:v>
                </c:pt>
                <c:pt idx="71">
                  <c:v>1.35E-2</c:v>
                </c:pt>
                <c:pt idx="72">
                  <c:v>5.5999999999999999E-3</c:v>
                </c:pt>
                <c:pt idx="73">
                  <c:v>0</c:v>
                </c:pt>
                <c:pt idx="74">
                  <c:v>4.4000000000000003E-3</c:v>
                </c:pt>
                <c:pt idx="75">
                  <c:v>0</c:v>
                </c:pt>
                <c:pt idx="76">
                  <c:v>0</c:v>
                </c:pt>
                <c:pt idx="77">
                  <c:v>0</c:v>
                </c:pt>
                <c:pt idx="78">
                  <c:v>4.4999999999999997E-3</c:v>
                </c:pt>
                <c:pt idx="79">
                  <c:v>6.1000000000000004E-3</c:v>
                </c:pt>
                <c:pt idx="80">
                  <c:v>0</c:v>
                </c:pt>
                <c:pt idx="81">
                  <c:v>1.5699999999999999E-2</c:v>
                </c:pt>
                <c:pt idx="82">
                  <c:v>0</c:v>
                </c:pt>
                <c:pt idx="83">
                  <c:v>0</c:v>
                </c:pt>
                <c:pt idx="84">
                  <c:v>3.7000000000000002E-3</c:v>
                </c:pt>
                <c:pt idx="85">
                  <c:v>0</c:v>
                </c:pt>
                <c:pt idx="86">
                  <c:v>0</c:v>
                </c:pt>
                <c:pt idx="87">
                  <c:v>0</c:v>
                </c:pt>
                <c:pt idx="88">
                  <c:v>0</c:v>
                </c:pt>
                <c:pt idx="89">
                  <c:v>0</c:v>
                </c:pt>
                <c:pt idx="90">
                  <c:v>5.1000000000000004E-3</c:v>
                </c:pt>
                <c:pt idx="91">
                  <c:v>0</c:v>
                </c:pt>
                <c:pt idx="92">
                  <c:v>6.1000000000000004E-3</c:v>
                </c:pt>
                <c:pt idx="93">
                  <c:v>1.2200000000000001E-2</c:v>
                </c:pt>
                <c:pt idx="94">
                  <c:v>0</c:v>
                </c:pt>
                <c:pt idx="95">
                  <c:v>0</c:v>
                </c:pt>
                <c:pt idx="96">
                  <c:v>5.5999999999999999E-3</c:v>
                </c:pt>
                <c:pt idx="97">
                  <c:v>5.7999999999999996E-3</c:v>
                </c:pt>
                <c:pt idx="98">
                  <c:v>7.1000000000000004E-3</c:v>
                </c:pt>
                <c:pt idx="99">
                  <c:v>6.4999999999999997E-3</c:v>
                </c:pt>
                <c:pt idx="100">
                  <c:v>6.4000000000000003E-3</c:v>
                </c:pt>
                <c:pt idx="101">
                  <c:v>5.8999999999999999E-3</c:v>
                </c:pt>
                <c:pt idx="102">
                  <c:v>0</c:v>
                </c:pt>
                <c:pt idx="103">
                  <c:v>0</c:v>
                </c:pt>
                <c:pt idx="104">
                  <c:v>0</c:v>
                </c:pt>
                <c:pt idx="105">
                  <c:v>4.7300000000000002E-2</c:v>
                </c:pt>
                <c:pt idx="106">
                  <c:v>3.3999999999999998E-3</c:v>
                </c:pt>
                <c:pt idx="107">
                  <c:v>0</c:v>
                </c:pt>
                <c:pt idx="108">
                  <c:v>0</c:v>
                </c:pt>
                <c:pt idx="109">
                  <c:v>8.8999999999999999E-3</c:v>
                </c:pt>
                <c:pt idx="110">
                  <c:v>5.0000000000000001E-3</c:v>
                </c:pt>
                <c:pt idx="111">
                  <c:v>0</c:v>
                </c:pt>
                <c:pt idx="112">
                  <c:v>8.3000000000000001E-3</c:v>
                </c:pt>
                <c:pt idx="113">
                  <c:v>6.8999999999999999E-3</c:v>
                </c:pt>
                <c:pt idx="114">
                  <c:v>0.48470000000000002</c:v>
                </c:pt>
                <c:pt idx="115">
                  <c:v>8.3699999999999997E-2</c:v>
                </c:pt>
                <c:pt idx="116">
                  <c:v>1.6302000000000001</c:v>
                </c:pt>
                <c:pt idx="117">
                  <c:v>3.0800000000000001E-2</c:v>
                </c:pt>
                <c:pt idx="118">
                  <c:v>3.7498</c:v>
                </c:pt>
                <c:pt idx="119">
                  <c:v>8.4898000000000007</c:v>
                </c:pt>
                <c:pt idx="120">
                  <c:v>10.7242</c:v>
                </c:pt>
                <c:pt idx="121">
                  <c:v>0.47670000000000001</c:v>
                </c:pt>
                <c:pt idx="122">
                  <c:v>6.4104000000000001</c:v>
                </c:pt>
                <c:pt idx="123">
                  <c:v>25.2181</c:v>
                </c:pt>
                <c:pt idx="124">
                  <c:v>7.5743</c:v>
                </c:pt>
                <c:pt idx="125">
                  <c:v>3.7900000000000003E-2</c:v>
                </c:pt>
                <c:pt idx="126">
                  <c:v>0.92300000000000004</c:v>
                </c:pt>
                <c:pt idx="127">
                  <c:v>7.9654999999999996</c:v>
                </c:pt>
                <c:pt idx="128">
                  <c:v>0.54730000000000001</c:v>
                </c:pt>
                <c:pt idx="129">
                  <c:v>3.2145000000000001</c:v>
                </c:pt>
                <c:pt idx="130">
                  <c:v>2.0400000000000001E-2</c:v>
                </c:pt>
                <c:pt idx="131">
                  <c:v>2.7347999999999999</c:v>
                </c:pt>
                <c:pt idx="132">
                  <c:v>0.36399999999999999</c:v>
                </c:pt>
                <c:pt idx="133">
                  <c:v>5.7263000000000002</c:v>
                </c:pt>
                <c:pt idx="134">
                  <c:v>1.4458</c:v>
                </c:pt>
                <c:pt idx="135">
                  <c:v>2.5287999999999999</c:v>
                </c:pt>
                <c:pt idx="136">
                  <c:v>1.5209999999999999</c:v>
                </c:pt>
                <c:pt idx="137">
                  <c:v>5.7652999999999999</c:v>
                </c:pt>
                <c:pt idx="138">
                  <c:v>2.7E-2</c:v>
                </c:pt>
                <c:pt idx="139">
                  <c:v>12.554399999999999</c:v>
                </c:pt>
                <c:pt idx="140">
                  <c:v>7.3280000000000003</c:v>
                </c:pt>
                <c:pt idx="141">
                  <c:v>2.8199999999999999E-2</c:v>
                </c:pt>
                <c:pt idx="142">
                  <c:v>4.9798999999999998</c:v>
                </c:pt>
                <c:pt idx="143">
                  <c:v>2.7902999999999998</c:v>
                </c:pt>
                <c:pt idx="144">
                  <c:v>7.4128999999999996</c:v>
                </c:pt>
                <c:pt idx="145">
                  <c:v>1.5699999999999999E-2</c:v>
                </c:pt>
                <c:pt idx="146">
                  <c:v>2.0899999999999998E-2</c:v>
                </c:pt>
                <c:pt idx="147">
                  <c:v>2.4400000000000002E-2</c:v>
                </c:pt>
              </c:numCache>
            </c:numRef>
          </c:val>
        </c:ser>
        <c:dLbls>
          <c:showLegendKey val="0"/>
          <c:showVal val="0"/>
          <c:showCatName val="0"/>
          <c:showSerName val="0"/>
          <c:showPercent val="0"/>
          <c:showBubbleSize val="0"/>
        </c:dLbls>
        <c:gapWidth val="150"/>
        <c:axId val="356493552"/>
        <c:axId val="356494336"/>
      </c:barChart>
      <c:catAx>
        <c:axId val="356493552"/>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56494336"/>
        <c:crosses val="autoZero"/>
        <c:auto val="1"/>
        <c:lblAlgn val="ctr"/>
        <c:lblOffset val="100"/>
        <c:noMultiLvlLbl val="0"/>
      </c:catAx>
      <c:valAx>
        <c:axId val="356494336"/>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2</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3.0783131167302798E-2"/>
              <c:y val="0.34986683330391738"/>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5649355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r>
              <a:rPr lang="en-US" sz="1800" b="1">
                <a:solidFill>
                  <a:sysClr val="windowText" lastClr="000000"/>
                </a:solidFill>
              </a:rPr>
              <a:t>Single cell analysis of the HPAT3 expression in human embryos</a:t>
            </a:r>
          </a:p>
        </c:rich>
      </c:tx>
      <c:overlay val="0"/>
      <c:spPr>
        <a:noFill/>
        <a:ln>
          <a:noFill/>
        </a:ln>
        <a:effectLst/>
      </c:spPr>
      <c:txPr>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9113141107472505E-2"/>
          <c:y val="0.12109137858933935"/>
          <c:w val="0.88476236161441657"/>
          <c:h val="0.6965831413347835"/>
        </c:manualLayout>
      </c:layout>
      <c:barChart>
        <c:barDir val="col"/>
        <c:grouping val="clustered"/>
        <c:varyColors val="0"/>
        <c:ser>
          <c:idx val="0"/>
          <c:order val="0"/>
          <c:tx>
            <c:strRef>
              <c:f>Sheet9!$A$9</c:f>
              <c:strCache>
                <c:ptCount val="1"/>
                <c:pt idx="0">
                  <c:v>HPAT3</c:v>
                </c:pt>
              </c:strCache>
            </c:strRef>
          </c:tx>
          <c:spPr>
            <a:solidFill>
              <a:srgbClr val="0070C0"/>
            </a:solidFill>
            <a:ln>
              <a:solidFill>
                <a:schemeClr val="accent1"/>
              </a:solidFill>
            </a:ln>
            <a:effectLst/>
          </c:spPr>
          <c:invertIfNegative val="0"/>
          <c:cat>
            <c:strRef>
              <c:f>Sheet9!$B$8:$ES$8</c:f>
              <c:strCache>
                <c:ptCount val="148"/>
                <c:pt idx="0">
                  <c:v>Oocyte</c:v>
                </c:pt>
                <c:pt idx="1">
                  <c:v>Oocyte</c:v>
                </c:pt>
                <c:pt idx="2">
                  <c:v>Oocyte</c:v>
                </c:pt>
                <c:pt idx="3">
                  <c:v>Oocyte</c:v>
                </c:pt>
                <c:pt idx="4">
                  <c:v>Oocyte</c:v>
                </c:pt>
                <c:pt idx="5">
                  <c:v>Oocyte</c:v>
                </c:pt>
                <c:pt idx="6">
                  <c:v>Pronuclei</c:v>
                </c:pt>
                <c:pt idx="7">
                  <c:v>Pronuclei</c:v>
                </c:pt>
                <c:pt idx="8">
                  <c:v>Pronuclei</c:v>
                </c:pt>
                <c:pt idx="9">
                  <c:v>Zygote</c:v>
                </c:pt>
                <c:pt idx="10">
                  <c:v>Zygote</c:v>
                </c:pt>
                <c:pt idx="11">
                  <c:v>Zygote</c:v>
                </c:pt>
                <c:pt idx="12">
                  <c:v>Zygote</c:v>
                </c:pt>
                <c:pt idx="13">
                  <c:v>Zygote</c:v>
                </c:pt>
                <c:pt idx="14">
                  <c:v>2-cell</c:v>
                </c:pt>
                <c:pt idx="15">
                  <c:v>2-cell</c:v>
                </c:pt>
                <c:pt idx="16">
                  <c:v>2-cell</c:v>
                </c:pt>
                <c:pt idx="17">
                  <c:v>2-cell</c:v>
                </c:pt>
                <c:pt idx="18">
                  <c:v>2-cell</c:v>
                </c:pt>
                <c:pt idx="19">
                  <c:v>2-cell</c:v>
                </c:pt>
                <c:pt idx="20">
                  <c:v>2-cell</c:v>
                </c:pt>
                <c:pt idx="21">
                  <c:v>2-cell</c:v>
                </c:pt>
                <c:pt idx="22">
                  <c:v>2-cell</c:v>
                </c:pt>
                <c:pt idx="23">
                  <c:v>4-cell</c:v>
                </c:pt>
                <c:pt idx="24">
                  <c:v>4-cell</c:v>
                </c:pt>
                <c:pt idx="25">
                  <c:v>4-cell</c:v>
                </c:pt>
                <c:pt idx="26">
                  <c:v>4-cell</c:v>
                </c:pt>
                <c:pt idx="27">
                  <c:v>4-cell</c:v>
                </c:pt>
                <c:pt idx="28">
                  <c:v>4-cell</c:v>
                </c:pt>
                <c:pt idx="29">
                  <c:v>4-cell</c:v>
                </c:pt>
                <c:pt idx="30">
                  <c:v>4-cell</c:v>
                </c:pt>
                <c:pt idx="31">
                  <c:v>4-cell</c:v>
                </c:pt>
                <c:pt idx="32">
                  <c:v>4-cell</c:v>
                </c:pt>
                <c:pt idx="33">
                  <c:v>4-cell</c:v>
                </c:pt>
                <c:pt idx="34">
                  <c:v>4-cell</c:v>
                </c:pt>
                <c:pt idx="35">
                  <c:v>4-cell</c:v>
                </c:pt>
                <c:pt idx="36">
                  <c:v>4-cell</c:v>
                </c:pt>
                <c:pt idx="37">
                  <c:v>4-cell</c:v>
                </c:pt>
                <c:pt idx="38">
                  <c:v>4-cell</c:v>
                </c:pt>
                <c:pt idx="39">
                  <c:v>8-cell</c:v>
                </c:pt>
                <c:pt idx="40">
                  <c:v>8-cell</c:v>
                </c:pt>
                <c:pt idx="41">
                  <c:v>8-cell</c:v>
                </c:pt>
                <c:pt idx="42">
                  <c:v>8-cell</c:v>
                </c:pt>
                <c:pt idx="43">
                  <c:v>8-cell</c:v>
                </c:pt>
                <c:pt idx="44">
                  <c:v>8-cell</c:v>
                </c:pt>
                <c:pt idx="45">
                  <c:v>8-cell</c:v>
                </c:pt>
                <c:pt idx="46">
                  <c:v>8-cell</c:v>
                </c:pt>
                <c:pt idx="47">
                  <c:v>8-cell</c:v>
                </c:pt>
                <c:pt idx="48">
                  <c:v>8-cell</c:v>
                </c:pt>
                <c:pt idx="49">
                  <c:v>8-cell</c:v>
                </c:pt>
                <c:pt idx="50">
                  <c:v>8-cell</c:v>
                </c:pt>
                <c:pt idx="51">
                  <c:v>8-cell</c:v>
                </c:pt>
                <c:pt idx="52">
                  <c:v>8-cell</c:v>
                </c:pt>
                <c:pt idx="53">
                  <c:v>8-cell</c:v>
                </c:pt>
                <c:pt idx="54">
                  <c:v>8-cell</c:v>
                </c:pt>
                <c:pt idx="55">
                  <c:v>8-cell</c:v>
                </c:pt>
                <c:pt idx="56">
                  <c:v>8-cell</c:v>
                </c:pt>
                <c:pt idx="57">
                  <c:v>8-cell</c:v>
                </c:pt>
                <c:pt idx="58">
                  <c:v>8-cell</c:v>
                </c:pt>
                <c:pt idx="59">
                  <c:v>8-cell</c:v>
                </c:pt>
                <c:pt idx="60">
                  <c:v>8-cell</c:v>
                </c:pt>
                <c:pt idx="61">
                  <c:v>8-cell</c:v>
                </c:pt>
                <c:pt idx="62">
                  <c:v>8-cell</c:v>
                </c:pt>
                <c:pt idx="63">
                  <c:v>8-cell</c:v>
                </c:pt>
                <c:pt idx="64">
                  <c:v>8-cell</c:v>
                </c:pt>
                <c:pt idx="65">
                  <c:v>Morulae</c:v>
                </c:pt>
                <c:pt idx="66">
                  <c:v>Morulae</c:v>
                </c:pt>
                <c:pt idx="67">
                  <c:v>Morulae</c:v>
                </c:pt>
                <c:pt idx="68">
                  <c:v>Morulae</c:v>
                </c:pt>
                <c:pt idx="69">
                  <c:v>Morulae</c:v>
                </c:pt>
                <c:pt idx="70">
                  <c:v>Morulae</c:v>
                </c:pt>
                <c:pt idx="71">
                  <c:v>Morulae</c:v>
                </c:pt>
                <c:pt idx="72">
                  <c:v>Morulae</c:v>
                </c:pt>
                <c:pt idx="73">
                  <c:v>Morulae</c:v>
                </c:pt>
                <c:pt idx="74">
                  <c:v>Morulae</c:v>
                </c:pt>
                <c:pt idx="75">
                  <c:v>Morulae</c:v>
                </c:pt>
                <c:pt idx="76">
                  <c:v>Morulae</c:v>
                </c:pt>
                <c:pt idx="77">
                  <c:v>Morulae</c:v>
                </c:pt>
                <c:pt idx="78">
                  <c:v>Morulae</c:v>
                </c:pt>
                <c:pt idx="79">
                  <c:v>Morulae</c:v>
                </c:pt>
                <c:pt idx="80">
                  <c:v>Morulae</c:v>
                </c:pt>
                <c:pt idx="81">
                  <c:v>Morulae</c:v>
                </c:pt>
                <c:pt idx="82">
                  <c:v>Morulae</c:v>
                </c:pt>
                <c:pt idx="83">
                  <c:v>Morulae</c:v>
                </c:pt>
                <c:pt idx="84">
                  <c:v>Late_blastocyst</c:v>
                </c:pt>
                <c:pt idx="85">
                  <c:v>Late_blastocyst</c:v>
                </c:pt>
                <c:pt idx="86">
                  <c:v>Late_blastocyst</c:v>
                </c:pt>
                <c:pt idx="87">
                  <c:v>Late_blastocyst</c:v>
                </c:pt>
                <c:pt idx="88">
                  <c:v>Late_blastocyst</c:v>
                </c:pt>
                <c:pt idx="89">
                  <c:v>Late_blastocyst</c:v>
                </c:pt>
                <c:pt idx="90">
                  <c:v>Late_blastocyst</c:v>
                </c:pt>
                <c:pt idx="91">
                  <c:v>Late_blastocyst</c:v>
                </c:pt>
                <c:pt idx="92">
                  <c:v>Late_blastocyst</c:v>
                </c:pt>
                <c:pt idx="93">
                  <c:v>Late_blastocyst</c:v>
                </c:pt>
                <c:pt idx="94">
                  <c:v>Late_blastocyst</c:v>
                </c:pt>
                <c:pt idx="95">
                  <c:v>Late_blastocyst</c:v>
                </c:pt>
                <c:pt idx="96">
                  <c:v>Late_blastocyst</c:v>
                </c:pt>
                <c:pt idx="97">
                  <c:v>Late_blastocyst</c:v>
                </c:pt>
                <c:pt idx="98">
                  <c:v>Late_blastocyst</c:v>
                </c:pt>
                <c:pt idx="99">
                  <c:v>Late_blastocyst</c:v>
                </c:pt>
                <c:pt idx="100">
                  <c:v>Late_blastocyst</c:v>
                </c:pt>
                <c:pt idx="101">
                  <c:v>Late_blastocyst</c:v>
                </c:pt>
                <c:pt idx="102">
                  <c:v>Late_blastocyst</c:v>
                </c:pt>
                <c:pt idx="103">
                  <c:v>Late_blastocyst</c:v>
                </c:pt>
                <c:pt idx="104">
                  <c:v>Late_blastocyst</c:v>
                </c:pt>
                <c:pt idx="105">
                  <c:v>Late_blastocyst</c:v>
                </c:pt>
                <c:pt idx="106">
                  <c:v>Late_blastocyst</c:v>
                </c:pt>
                <c:pt idx="107">
                  <c:v>Late_blastocyst</c:v>
                </c:pt>
                <c:pt idx="108">
                  <c:v>Late_blastocyst</c:v>
                </c:pt>
                <c:pt idx="109">
                  <c:v>Late_blastocyst</c:v>
                </c:pt>
                <c:pt idx="110">
                  <c:v>Late_blastocyst</c:v>
                </c:pt>
                <c:pt idx="111">
                  <c:v>Late_blastocyst</c:v>
                </c:pt>
                <c:pt idx="112">
                  <c:v>Late_blastocyst</c:v>
                </c:pt>
                <c:pt idx="113">
                  <c:v>Late_blastocyst</c:v>
                </c:pt>
                <c:pt idx="114">
                  <c:v>hESC_P0</c:v>
                </c:pt>
                <c:pt idx="115">
                  <c:v>hESC_P0</c:v>
                </c:pt>
                <c:pt idx="116">
                  <c:v>hESC_P0</c:v>
                </c:pt>
                <c:pt idx="117">
                  <c:v>hESC_P0</c:v>
                </c:pt>
                <c:pt idx="118">
                  <c:v>hESC_P0</c:v>
                </c:pt>
                <c:pt idx="119">
                  <c:v>hESC_P0</c:v>
                </c:pt>
                <c:pt idx="120">
                  <c:v>hESC_P0</c:v>
                </c:pt>
                <c:pt idx="121">
                  <c:v>hESC_P0</c:v>
                </c:pt>
                <c:pt idx="122">
                  <c:v>hESC_P10</c:v>
                </c:pt>
                <c:pt idx="123">
                  <c:v>hESC_P10</c:v>
                </c:pt>
                <c:pt idx="124">
                  <c:v>hESC_P10</c:v>
                </c:pt>
                <c:pt idx="125">
                  <c:v>hESC_P10</c:v>
                </c:pt>
                <c:pt idx="126">
                  <c:v>hESC_P10</c:v>
                </c:pt>
                <c:pt idx="127">
                  <c:v>hESC_P10</c:v>
                </c:pt>
                <c:pt idx="128">
                  <c:v>hESC_P10</c:v>
                </c:pt>
                <c:pt idx="129">
                  <c:v>hESC_P10</c:v>
                </c:pt>
                <c:pt idx="130">
                  <c:v>hESC_P10</c:v>
                </c:pt>
                <c:pt idx="131">
                  <c:v>hESC_P10</c:v>
                </c:pt>
                <c:pt idx="132">
                  <c:v>hESC_P10</c:v>
                </c:pt>
                <c:pt idx="133">
                  <c:v>hESC_P10</c:v>
                </c:pt>
                <c:pt idx="134">
                  <c:v>hESC_P10</c:v>
                </c:pt>
                <c:pt idx="135">
                  <c:v>hESC_P10</c:v>
                </c:pt>
                <c:pt idx="136">
                  <c:v>hESC_P10</c:v>
                </c:pt>
                <c:pt idx="137">
                  <c:v>hESC_P10</c:v>
                </c:pt>
                <c:pt idx="138">
                  <c:v>hESC_P10</c:v>
                </c:pt>
                <c:pt idx="139">
                  <c:v>hESC_P10</c:v>
                </c:pt>
                <c:pt idx="140">
                  <c:v>hESC_P10</c:v>
                </c:pt>
                <c:pt idx="141">
                  <c:v>hESC_P10</c:v>
                </c:pt>
                <c:pt idx="142">
                  <c:v>hESC_P10</c:v>
                </c:pt>
                <c:pt idx="143">
                  <c:v>hESC_P10</c:v>
                </c:pt>
                <c:pt idx="144">
                  <c:v>hESC_P10</c:v>
                </c:pt>
                <c:pt idx="145">
                  <c:v>hESC_P10</c:v>
                </c:pt>
                <c:pt idx="146">
                  <c:v>hESC_P10</c:v>
                </c:pt>
                <c:pt idx="147">
                  <c:v>hESC_P10</c:v>
                </c:pt>
              </c:strCache>
            </c:strRef>
          </c:cat>
          <c:val>
            <c:numRef>
              <c:f>Sheet9!$B$9:$ES$9</c:f>
              <c:numCache>
                <c:formatCode>General</c:formatCode>
                <c:ptCount val="148"/>
                <c:pt idx="0">
                  <c:v>5.4100000000000002E-2</c:v>
                </c:pt>
                <c:pt idx="1">
                  <c:v>1.1599999999999999E-2</c:v>
                </c:pt>
                <c:pt idx="2">
                  <c:v>0.1603</c:v>
                </c:pt>
                <c:pt idx="3">
                  <c:v>0</c:v>
                </c:pt>
                <c:pt idx="4">
                  <c:v>0</c:v>
                </c:pt>
                <c:pt idx="5">
                  <c:v>0</c:v>
                </c:pt>
                <c:pt idx="6">
                  <c:v>1.4E-2</c:v>
                </c:pt>
                <c:pt idx="7">
                  <c:v>5.3499999999999999E-2</c:v>
                </c:pt>
                <c:pt idx="8">
                  <c:v>0.19520000000000001</c:v>
                </c:pt>
                <c:pt idx="9">
                  <c:v>0.36080000000000001</c:v>
                </c:pt>
                <c:pt idx="10">
                  <c:v>0.14630000000000001</c:v>
                </c:pt>
                <c:pt idx="11">
                  <c:v>0.13880000000000001</c:v>
                </c:pt>
                <c:pt idx="12">
                  <c:v>0.4375</c:v>
                </c:pt>
                <c:pt idx="13">
                  <c:v>0.31869999999999998</c:v>
                </c:pt>
                <c:pt idx="14">
                  <c:v>0.2379</c:v>
                </c:pt>
                <c:pt idx="15">
                  <c:v>0.20910000000000001</c:v>
                </c:pt>
                <c:pt idx="16">
                  <c:v>0.2354</c:v>
                </c:pt>
                <c:pt idx="17">
                  <c:v>0.48149999999999998</c:v>
                </c:pt>
                <c:pt idx="18">
                  <c:v>5.1200000000000002E-2</c:v>
                </c:pt>
                <c:pt idx="19">
                  <c:v>3.9100000000000003E-2</c:v>
                </c:pt>
                <c:pt idx="20">
                  <c:v>0</c:v>
                </c:pt>
                <c:pt idx="21">
                  <c:v>0</c:v>
                </c:pt>
                <c:pt idx="22">
                  <c:v>3.6299999999999999E-2</c:v>
                </c:pt>
                <c:pt idx="23">
                  <c:v>0.22109999999999999</c:v>
                </c:pt>
                <c:pt idx="24">
                  <c:v>0.1055</c:v>
                </c:pt>
                <c:pt idx="25">
                  <c:v>0.57210000000000005</c:v>
                </c:pt>
                <c:pt idx="26">
                  <c:v>1.6899999999999998E-2</c:v>
                </c:pt>
                <c:pt idx="27">
                  <c:v>4.5999999999999999E-2</c:v>
                </c:pt>
                <c:pt idx="28">
                  <c:v>0.1023</c:v>
                </c:pt>
                <c:pt idx="29">
                  <c:v>5.8799999999999998E-2</c:v>
                </c:pt>
                <c:pt idx="30">
                  <c:v>0.14449999999999999</c:v>
                </c:pt>
                <c:pt idx="31">
                  <c:v>0.25430000000000003</c:v>
                </c:pt>
                <c:pt idx="32">
                  <c:v>4.7300000000000002E-2</c:v>
                </c:pt>
                <c:pt idx="33">
                  <c:v>0.2198</c:v>
                </c:pt>
                <c:pt idx="34">
                  <c:v>0.69420000000000004</c:v>
                </c:pt>
                <c:pt idx="35">
                  <c:v>3.1800000000000002E-2</c:v>
                </c:pt>
                <c:pt idx="36">
                  <c:v>0</c:v>
                </c:pt>
                <c:pt idx="37">
                  <c:v>0</c:v>
                </c:pt>
                <c:pt idx="38">
                  <c:v>7.3000000000000001E-3</c:v>
                </c:pt>
                <c:pt idx="39">
                  <c:v>1.12E-2</c:v>
                </c:pt>
                <c:pt idx="40">
                  <c:v>2.35E-2</c:v>
                </c:pt>
                <c:pt idx="41">
                  <c:v>1.61E-2</c:v>
                </c:pt>
                <c:pt idx="42">
                  <c:v>1.9400000000000001E-2</c:v>
                </c:pt>
                <c:pt idx="43">
                  <c:v>1.0999999999999999E-2</c:v>
                </c:pt>
                <c:pt idx="44">
                  <c:v>5.67E-2</c:v>
                </c:pt>
                <c:pt idx="45">
                  <c:v>5.5999999999999999E-3</c:v>
                </c:pt>
                <c:pt idx="46">
                  <c:v>8.3599999999999994E-2</c:v>
                </c:pt>
                <c:pt idx="47">
                  <c:v>0.44009999999999999</c:v>
                </c:pt>
                <c:pt idx="48">
                  <c:v>1.7545999999999999</c:v>
                </c:pt>
                <c:pt idx="49">
                  <c:v>2.3900000000000001E-2</c:v>
                </c:pt>
                <c:pt idx="50">
                  <c:v>0</c:v>
                </c:pt>
                <c:pt idx="51">
                  <c:v>0</c:v>
                </c:pt>
                <c:pt idx="52">
                  <c:v>1.9699999999999999E-2</c:v>
                </c:pt>
                <c:pt idx="53">
                  <c:v>1.46E-2</c:v>
                </c:pt>
                <c:pt idx="54">
                  <c:v>0.77300000000000002</c:v>
                </c:pt>
                <c:pt idx="55">
                  <c:v>0.03</c:v>
                </c:pt>
                <c:pt idx="56">
                  <c:v>5.3E-3</c:v>
                </c:pt>
                <c:pt idx="57">
                  <c:v>4.1000000000000003E-3</c:v>
                </c:pt>
                <c:pt idx="58">
                  <c:v>9.1000000000000004E-3</c:v>
                </c:pt>
                <c:pt idx="59">
                  <c:v>6.9500000000000006E-2</c:v>
                </c:pt>
                <c:pt idx="60">
                  <c:v>0</c:v>
                </c:pt>
                <c:pt idx="61">
                  <c:v>1.6899999999999998E-2</c:v>
                </c:pt>
                <c:pt idx="62">
                  <c:v>0</c:v>
                </c:pt>
                <c:pt idx="63">
                  <c:v>3.2899999999999999E-2</c:v>
                </c:pt>
                <c:pt idx="64">
                  <c:v>0</c:v>
                </c:pt>
                <c:pt idx="65">
                  <c:v>1.2E-2</c:v>
                </c:pt>
                <c:pt idx="66">
                  <c:v>0</c:v>
                </c:pt>
                <c:pt idx="67">
                  <c:v>0</c:v>
                </c:pt>
                <c:pt idx="68">
                  <c:v>1.37E-2</c:v>
                </c:pt>
                <c:pt idx="69">
                  <c:v>2.1000000000000001E-2</c:v>
                </c:pt>
                <c:pt idx="70">
                  <c:v>0</c:v>
                </c:pt>
                <c:pt idx="71">
                  <c:v>7.3000000000000001E-3</c:v>
                </c:pt>
                <c:pt idx="72">
                  <c:v>0</c:v>
                </c:pt>
                <c:pt idx="73">
                  <c:v>4.5999999999999999E-3</c:v>
                </c:pt>
                <c:pt idx="74">
                  <c:v>0</c:v>
                </c:pt>
                <c:pt idx="75">
                  <c:v>0</c:v>
                </c:pt>
                <c:pt idx="76">
                  <c:v>0</c:v>
                </c:pt>
                <c:pt idx="77">
                  <c:v>5.3E-3</c:v>
                </c:pt>
                <c:pt idx="78">
                  <c:v>0</c:v>
                </c:pt>
                <c:pt idx="79">
                  <c:v>6.7000000000000002E-3</c:v>
                </c:pt>
                <c:pt idx="80">
                  <c:v>9.5999999999999992E-3</c:v>
                </c:pt>
                <c:pt idx="81">
                  <c:v>0</c:v>
                </c:pt>
                <c:pt idx="82">
                  <c:v>0</c:v>
                </c:pt>
                <c:pt idx="83">
                  <c:v>0</c:v>
                </c:pt>
                <c:pt idx="84">
                  <c:v>1.5900000000000001E-2</c:v>
                </c:pt>
                <c:pt idx="85">
                  <c:v>8.3000000000000001E-3</c:v>
                </c:pt>
                <c:pt idx="86">
                  <c:v>1.0699999999999999E-2</c:v>
                </c:pt>
                <c:pt idx="87">
                  <c:v>4.8999999999999998E-3</c:v>
                </c:pt>
                <c:pt idx="88">
                  <c:v>2.1000000000000001E-2</c:v>
                </c:pt>
                <c:pt idx="89">
                  <c:v>3.6799999999999999E-2</c:v>
                </c:pt>
                <c:pt idx="90">
                  <c:v>0</c:v>
                </c:pt>
                <c:pt idx="91">
                  <c:v>1.89E-2</c:v>
                </c:pt>
                <c:pt idx="92">
                  <c:v>1.66E-2</c:v>
                </c:pt>
                <c:pt idx="93">
                  <c:v>1.9900000000000001E-2</c:v>
                </c:pt>
                <c:pt idx="94">
                  <c:v>9.9000000000000008E-3</c:v>
                </c:pt>
                <c:pt idx="95">
                  <c:v>0</c:v>
                </c:pt>
                <c:pt idx="96">
                  <c:v>7.8200000000000006E-2</c:v>
                </c:pt>
                <c:pt idx="97">
                  <c:v>0.92390000000000005</c:v>
                </c:pt>
                <c:pt idx="98">
                  <c:v>8.48E-2</c:v>
                </c:pt>
                <c:pt idx="99">
                  <c:v>3.5099999999999999E-2</c:v>
                </c:pt>
                <c:pt idx="100">
                  <c:v>0</c:v>
                </c:pt>
                <c:pt idx="101">
                  <c:v>1.2800000000000001E-2</c:v>
                </c:pt>
                <c:pt idx="102">
                  <c:v>1.9199999999999998E-2</c:v>
                </c:pt>
                <c:pt idx="103">
                  <c:v>0</c:v>
                </c:pt>
                <c:pt idx="104">
                  <c:v>5.1999999999999998E-3</c:v>
                </c:pt>
                <c:pt idx="105">
                  <c:v>5.1000000000000004E-3</c:v>
                </c:pt>
                <c:pt idx="106">
                  <c:v>3.5999999999999999E-3</c:v>
                </c:pt>
                <c:pt idx="107">
                  <c:v>0</c:v>
                </c:pt>
                <c:pt idx="108">
                  <c:v>1.78E-2</c:v>
                </c:pt>
                <c:pt idx="109">
                  <c:v>8.4582999999999995</c:v>
                </c:pt>
                <c:pt idx="110">
                  <c:v>6.4488000000000003</c:v>
                </c:pt>
                <c:pt idx="111">
                  <c:v>0</c:v>
                </c:pt>
                <c:pt idx="112">
                  <c:v>4.4999999999999997E-3</c:v>
                </c:pt>
                <c:pt idx="113">
                  <c:v>0</c:v>
                </c:pt>
                <c:pt idx="114">
                  <c:v>0.91369999999999996</c:v>
                </c:pt>
                <c:pt idx="115">
                  <c:v>1.1701999999999999</c:v>
                </c:pt>
                <c:pt idx="116">
                  <c:v>2.8818000000000001</c:v>
                </c:pt>
                <c:pt idx="117">
                  <c:v>3.3313000000000001</c:v>
                </c:pt>
                <c:pt idx="118">
                  <c:v>1.5542</c:v>
                </c:pt>
                <c:pt idx="119">
                  <c:v>3.0977000000000001</c:v>
                </c:pt>
                <c:pt idx="120">
                  <c:v>2.2349000000000001</c:v>
                </c:pt>
                <c:pt idx="121">
                  <c:v>1.6201000000000001</c:v>
                </c:pt>
                <c:pt idx="122">
                  <c:v>6.7799999999999999E-2</c:v>
                </c:pt>
                <c:pt idx="123">
                  <c:v>8.4599999999999995E-2</c:v>
                </c:pt>
                <c:pt idx="124">
                  <c:v>4.5999999999999999E-2</c:v>
                </c:pt>
                <c:pt idx="125">
                  <c:v>4.6199999999999998E-2</c:v>
                </c:pt>
                <c:pt idx="126">
                  <c:v>0.16420000000000001</c:v>
                </c:pt>
                <c:pt idx="127">
                  <c:v>1.6199999999999999E-2</c:v>
                </c:pt>
                <c:pt idx="128">
                  <c:v>3.2199999999999999E-2</c:v>
                </c:pt>
                <c:pt idx="129">
                  <c:v>0.45789999999999997</c:v>
                </c:pt>
                <c:pt idx="130">
                  <c:v>5.4999999999999997E-3</c:v>
                </c:pt>
                <c:pt idx="131">
                  <c:v>4.2000000000000003E-2</c:v>
                </c:pt>
                <c:pt idx="132">
                  <c:v>0</c:v>
                </c:pt>
                <c:pt idx="133">
                  <c:v>3.1699999999999999E-2</c:v>
                </c:pt>
                <c:pt idx="134">
                  <c:v>6.2899999999999998E-2</c:v>
                </c:pt>
                <c:pt idx="135">
                  <c:v>2.47E-2</c:v>
                </c:pt>
                <c:pt idx="136">
                  <c:v>5.5599999999999997E-2</c:v>
                </c:pt>
                <c:pt idx="137">
                  <c:v>2.53E-2</c:v>
                </c:pt>
                <c:pt idx="138">
                  <c:v>5.8400000000000001E-2</c:v>
                </c:pt>
                <c:pt idx="139">
                  <c:v>6.1899999999999997E-2</c:v>
                </c:pt>
                <c:pt idx="140">
                  <c:v>0.57110000000000005</c:v>
                </c:pt>
                <c:pt idx="141">
                  <c:v>3.0599999999999999E-2</c:v>
                </c:pt>
                <c:pt idx="142">
                  <c:v>6.3799999999999996E-2</c:v>
                </c:pt>
                <c:pt idx="143">
                  <c:v>2.64E-2</c:v>
                </c:pt>
                <c:pt idx="144">
                  <c:v>5.6599999999999998E-2</c:v>
                </c:pt>
                <c:pt idx="145">
                  <c:v>3.4000000000000002E-2</c:v>
                </c:pt>
                <c:pt idx="146">
                  <c:v>1.1299999999999999E-2</c:v>
                </c:pt>
                <c:pt idx="147">
                  <c:v>6.6E-3</c:v>
                </c:pt>
              </c:numCache>
            </c:numRef>
          </c:val>
        </c:ser>
        <c:dLbls>
          <c:showLegendKey val="0"/>
          <c:showVal val="0"/>
          <c:showCatName val="0"/>
          <c:showSerName val="0"/>
          <c:showPercent val="0"/>
          <c:showBubbleSize val="0"/>
        </c:dLbls>
        <c:gapWidth val="150"/>
        <c:axId val="356493944"/>
        <c:axId val="356491200"/>
      </c:barChart>
      <c:catAx>
        <c:axId val="356493944"/>
        <c:scaling>
          <c:orientation val="minMax"/>
        </c:scaling>
        <c:delete val="0"/>
        <c:axPos val="b"/>
        <c:title>
          <c:tx>
            <c:rich>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EMBRYOGENESIS</a:t>
                </a:r>
                <a:r>
                  <a:rPr lang="en-US" sz="1400" b="1" baseline="0">
                    <a:solidFill>
                      <a:sysClr val="windowText" lastClr="000000"/>
                    </a:solidFill>
                  </a:rPr>
                  <a:t> STAGE</a:t>
                </a:r>
                <a:endParaRPr lang="en-US" sz="1400" b="1">
                  <a:solidFill>
                    <a:sysClr val="windowText" lastClr="000000"/>
                  </a:solidFill>
                </a:endParaRPr>
              </a:p>
            </c:rich>
          </c:tx>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56491200"/>
        <c:crosses val="autoZero"/>
        <c:auto val="1"/>
        <c:lblAlgn val="ctr"/>
        <c:lblOffset val="100"/>
        <c:noMultiLvlLbl val="0"/>
      </c:catAx>
      <c:valAx>
        <c:axId val="356491200"/>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r>
                  <a:rPr lang="en-US" sz="1400" b="1">
                    <a:solidFill>
                      <a:sysClr val="windowText" lastClr="000000"/>
                    </a:solidFill>
                  </a:rPr>
                  <a:t>HPAT3</a:t>
                </a:r>
                <a:r>
                  <a:rPr lang="en-US" sz="1400" b="1" baseline="0">
                    <a:solidFill>
                      <a:sysClr val="windowText" lastClr="000000"/>
                    </a:solidFill>
                  </a:rPr>
                  <a:t> EXPRESSION</a:t>
                </a:r>
                <a:endParaRPr lang="en-US" sz="1400" b="1">
                  <a:solidFill>
                    <a:sysClr val="windowText" lastClr="000000"/>
                  </a:solidFill>
                </a:endParaRPr>
              </a:p>
            </c:rich>
          </c:tx>
          <c:layout>
            <c:manualLayout>
              <c:xMode val="edge"/>
              <c:yMode val="edge"/>
              <c:x val="2.6385541000545253E-2"/>
              <c:y val="0.35794428782450938"/>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mn-lt"/>
                <a:ea typeface="+mn-ea"/>
                <a:cs typeface="+mn-cs"/>
              </a:defRPr>
            </a:pPr>
            <a:endParaRPr lang="en-US"/>
          </a:p>
        </c:txPr>
        <c:crossAx val="35649394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7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ln w="9525" cap="flat" cmpd="sng" algn="ctr">
        <a:solidFill>
          <a:schemeClr val="tx1">
            <a:lumMod val="15000"/>
            <a:lumOff val="85000"/>
          </a:schemeClr>
        </a:solidFill>
        <a:round/>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01054</cdr:x>
      <cdr:y>0.36307</cdr:y>
    </cdr:from>
    <cdr:to>
      <cdr:x>0.05873</cdr:x>
      <cdr:y>0.68257</cdr:y>
    </cdr:to>
    <cdr:sp macro="" textlink="">
      <cdr:nvSpPr>
        <cdr:cNvPr id="2" name="TextBox 1"/>
        <cdr:cNvSpPr txBox="1"/>
      </cdr:nvSpPr>
      <cdr:spPr>
        <a:xfrm xmlns:a="http://schemas.openxmlformats.org/drawingml/2006/main" rot="16200000">
          <a:off x="-704590" y="3079315"/>
          <a:ext cx="2009384" cy="417534"/>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800" b="1">
              <a:solidFill>
                <a:sysClr val="windowText" lastClr="000000"/>
              </a:solidFill>
            </a:rPr>
            <a:t>Relative expression</a:t>
          </a:r>
        </a:p>
      </cdr:txBody>
    </cdr:sp>
  </cdr:relSizeAnchor>
</c:userShapes>
</file>

<file path=ppt/drawings/drawing2.xml><?xml version="1.0" encoding="utf-8"?>
<c:userShapes xmlns:c="http://schemas.openxmlformats.org/drawingml/2006/chart">
  <cdr:relSizeAnchor xmlns:cdr="http://schemas.openxmlformats.org/drawingml/2006/chartDrawing">
    <cdr:from>
      <cdr:x>0.02996</cdr:x>
      <cdr:y>0.32965</cdr:y>
    </cdr:from>
    <cdr:to>
      <cdr:x>0.07815</cdr:x>
      <cdr:y>0.64916</cdr:y>
    </cdr:to>
    <cdr:sp macro="" textlink="">
      <cdr:nvSpPr>
        <cdr:cNvPr id="2" name="TextBox 1"/>
        <cdr:cNvSpPr txBox="1"/>
      </cdr:nvSpPr>
      <cdr:spPr>
        <a:xfrm xmlns:a="http://schemas.openxmlformats.org/drawingml/2006/main" rot="16200000">
          <a:off x="-536358" y="2869156"/>
          <a:ext cx="2009384" cy="417534"/>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800" b="1" dirty="0">
              <a:solidFill>
                <a:sysClr val="windowText" lastClr="000000"/>
              </a:solidFill>
            </a:rPr>
            <a:t>Relative expression</a:t>
          </a:r>
        </a:p>
      </cdr:txBody>
    </cdr:sp>
  </cdr:relSizeAnchor>
</c:userShapes>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5/3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5/3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5/3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5/3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5/31/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s>
</file>

<file path=ppt/slides/_rels/slide10.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9.xml"/>
</Relationships>
</file>

<file path=ppt/slides/_rels/slide11.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emf"/>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1.xml"/>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2.xml"/>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3.xml"/>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4.xml"/>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5.xml"/>
</Relationships>
</file>

<file path=ppt/slides/_rels/slide7.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6.xml"/>
</Relationships>
</file>

<file path=ppt/slides/_rels/slide8.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7.xml"/>
</Relationships>
</file>

<file path=ppt/slides/_rels/slide9.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8.xml"/>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68490" y="2287552"/>
            <a:ext cx="11532359" cy="1697901"/>
          </a:xfrm>
          <a:prstGeom prst="rect">
            <a:avLst/>
          </a:prstGeom>
        </p:spPr>
        <p:txBody>
          <a:bodyPr wrap="square">
            <a:spAutoFit/>
          </a:bodyPr>
          <a:lstStyle/>
          <a:p>
            <a:pPr algn="ctr">
              <a:spcAft>
                <a:spcPts val="1000"/>
              </a:spcAft>
            </a:pPr>
            <a:r>
              <a:rPr lang="en-US" sz="1600" b="1" dirty="0">
                <a:latin typeface="Arial" panose="020B0604020202020204" pitchFamily="34" charset="0"/>
                <a:ea typeface="Calibri" panose="020F0502020204030204" pitchFamily="34" charset="0"/>
                <a:cs typeface="Arial" panose="020B0604020202020204" pitchFamily="34" charset="0"/>
              </a:rPr>
              <a:t>Supplemental Figure S3.</a:t>
            </a:r>
            <a:r>
              <a:rPr lang="en-US" sz="1600" dirty="0">
                <a:latin typeface="Arial" panose="020B0604020202020204" pitchFamily="34" charset="0"/>
                <a:ea typeface="Calibri" panose="020F0502020204030204" pitchFamily="34" charset="0"/>
                <a:cs typeface="Arial" panose="020B0604020202020204" pitchFamily="34" charset="0"/>
              </a:rPr>
              <a:t> Single-cell next generation sequencing-defined dynamics of expression changes of LTR7/HERVH loci of the HPAT </a:t>
            </a:r>
            <a:r>
              <a:rPr lang="en-US" sz="1600" dirty="0" err="1">
                <a:latin typeface="Arial" panose="020B0604020202020204" pitchFamily="34" charset="0"/>
                <a:ea typeface="Calibri" panose="020F0502020204030204" pitchFamily="34" charset="0"/>
                <a:cs typeface="Arial" panose="020B0604020202020204" pitchFamily="34" charset="0"/>
              </a:rPr>
              <a:t>lincRNA</a:t>
            </a:r>
            <a:r>
              <a:rPr lang="en-US" sz="1600" dirty="0">
                <a:latin typeface="Arial" panose="020B0604020202020204" pitchFamily="34" charset="0"/>
                <a:ea typeface="Calibri" panose="020F0502020204030204" pitchFamily="34" charset="0"/>
                <a:cs typeface="Arial" panose="020B0604020202020204" pitchFamily="34" charset="0"/>
              </a:rPr>
              <a:t> genes during human preimplantation embryonic development. </a:t>
            </a:r>
          </a:p>
          <a:p>
            <a:pPr algn="ctr">
              <a:spcAft>
                <a:spcPts val="1000"/>
              </a:spcAft>
            </a:pPr>
            <a:r>
              <a:rPr lang="en-US" sz="1600" dirty="0">
                <a:latin typeface="Arial" panose="020B0604020202020204" pitchFamily="34" charset="0"/>
                <a:ea typeface="Calibri" panose="020F0502020204030204" pitchFamily="34" charset="0"/>
                <a:cs typeface="Arial" panose="020B0604020202020204" pitchFamily="34" charset="0"/>
              </a:rPr>
              <a:t>Panels (A-E) show the patterns of expression changes defined by the mean expression values of transcripts encoded by the designated loci at corresponding stages of human embryogenesis. Panels (F-I) report the expression values of designated transcripts in 156 individual cells recovered from the human embryos at the designated developmental stages. Results of the additional analyses are reported in the Supplemental Fig. S2.2. </a:t>
            </a:r>
            <a:endParaRPr lang="en-U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1273878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I</a:t>
            </a:r>
          </a:p>
        </p:txBody>
      </p:sp>
    </p:spTree>
    <p:extLst>
      <p:ext uri="{BB962C8B-B14F-4D97-AF65-F5344CB8AC3E}">
        <p14:creationId xmlns:p14="http://schemas.microsoft.com/office/powerpoint/2010/main" val="194317555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60378" y="898264"/>
            <a:ext cx="11836004" cy="4948462"/>
          </a:xfrm>
          <a:prstGeom prst="rect">
            <a:avLst/>
          </a:prstGeom>
        </p:spPr>
      </p:pic>
      <p:sp>
        <p:nvSpPr>
          <p:cNvPr id="3" name="Rectangle 2"/>
          <p:cNvSpPr/>
          <p:nvPr/>
        </p:nvSpPr>
        <p:spPr>
          <a:xfrm>
            <a:off x="1774209" y="5513696"/>
            <a:ext cx="423081" cy="1228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p:cNvSpPr/>
          <p:nvPr/>
        </p:nvSpPr>
        <p:spPr>
          <a:xfrm>
            <a:off x="1774209" y="3687172"/>
            <a:ext cx="423081" cy="12055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1774208" y="5292122"/>
            <a:ext cx="423081" cy="12055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J</a:t>
            </a:r>
          </a:p>
        </p:txBody>
      </p:sp>
      <p:sp>
        <p:nvSpPr>
          <p:cNvPr id="8" name="Rectangle 7"/>
          <p:cNvSpPr/>
          <p:nvPr/>
        </p:nvSpPr>
        <p:spPr>
          <a:xfrm>
            <a:off x="1774207" y="5412676"/>
            <a:ext cx="423081" cy="1010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1774206" y="4924035"/>
            <a:ext cx="423081" cy="1010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3996627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1504849295"/>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401087696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56249283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5" name="TextBox 4"/>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126866683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2560732932"/>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9221571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79686101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36528027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ext uri="{D42A27DB-BD31-4B8C-83A1-F6EECF244321}">
                <p14:modId xmlns:p14="http://schemas.microsoft.com/office/powerpoint/2010/main" val="1120899242"/>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G</a:t>
            </a:r>
          </a:p>
        </p:txBody>
      </p:sp>
    </p:spTree>
    <p:extLst>
      <p:ext uri="{BB962C8B-B14F-4D97-AF65-F5344CB8AC3E}">
        <p14:creationId xmlns:p14="http://schemas.microsoft.com/office/powerpoint/2010/main" val="16049399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TextBox 3"/>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H</a:t>
            </a:r>
          </a:p>
        </p:txBody>
      </p:sp>
    </p:spTree>
    <p:extLst>
      <p:ext uri="{BB962C8B-B14F-4D97-AF65-F5344CB8AC3E}">
        <p14:creationId xmlns:p14="http://schemas.microsoft.com/office/powerpoint/2010/main" val="170150727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051</TotalTime>
  <Words>257</Words>
  <Application>Microsoft Office PowerPoint</Application>
  <PresentationFormat>Widescreen</PresentationFormat>
  <Paragraphs>34</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xsi="http://www.w3.org/2001/XMLSchema-instance"/>
</file>